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58" r:id="rId3"/>
    <p:sldId id="257" r:id="rId4"/>
    <p:sldId id="259" r:id="rId5"/>
    <p:sldId id="260" r:id="rId6"/>
    <p:sldId id="262"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0000FF"/>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52" d="100"/>
          <a:sy n="152" d="100"/>
        </p:scale>
        <p:origin x="53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uhammad Usman Tariq" userId="03ce5289-4d1e-4316-81c6-77963b418d72" providerId="ADAL" clId="{00010A79-167B-45EE-9014-DB57E5BF94F8}"/>
    <pc:docChg chg="undo custSel addSld delSld modSld">
      <pc:chgData name="Muhammad Usman Tariq" userId="03ce5289-4d1e-4316-81c6-77963b418d72" providerId="ADAL" clId="{00010A79-167B-45EE-9014-DB57E5BF94F8}" dt="2021-08-30T04:54:16.683" v="127" actId="1076"/>
      <pc:docMkLst>
        <pc:docMk/>
      </pc:docMkLst>
      <pc:sldChg chg="addSp modSp mod">
        <pc:chgData name="Muhammad Usman Tariq" userId="03ce5289-4d1e-4316-81c6-77963b418d72" providerId="ADAL" clId="{00010A79-167B-45EE-9014-DB57E5BF94F8}" dt="2021-08-25T23:44:56.363" v="22" actId="14100"/>
        <pc:sldMkLst>
          <pc:docMk/>
          <pc:sldMk cId="495918903" sldId="261"/>
        </pc:sldMkLst>
        <pc:spChg chg="mod">
          <ac:chgData name="Muhammad Usman Tariq" userId="03ce5289-4d1e-4316-81c6-77963b418d72" providerId="ADAL" clId="{00010A79-167B-45EE-9014-DB57E5BF94F8}" dt="2021-08-25T23:44:56.363" v="22" actId="14100"/>
          <ac:spMkLst>
            <pc:docMk/>
            <pc:sldMk cId="495918903" sldId="261"/>
            <ac:spMk id="2" creationId="{EDD8D71D-F75E-4E1B-B133-00FD006678FA}"/>
          </ac:spMkLst>
        </pc:spChg>
        <pc:spChg chg="add mod">
          <ac:chgData name="Muhammad Usman Tariq" userId="03ce5289-4d1e-4316-81c6-77963b418d72" providerId="ADAL" clId="{00010A79-167B-45EE-9014-DB57E5BF94F8}" dt="2021-08-25T23:44:19.848" v="13" actId="20577"/>
          <ac:spMkLst>
            <pc:docMk/>
            <pc:sldMk cId="495918903" sldId="261"/>
            <ac:spMk id="12" creationId="{520F1FBB-D9FB-453F-BBCF-27581D6F717F}"/>
          </ac:spMkLst>
        </pc:spChg>
        <pc:spChg chg="add mod">
          <ac:chgData name="Muhammad Usman Tariq" userId="03ce5289-4d1e-4316-81c6-77963b418d72" providerId="ADAL" clId="{00010A79-167B-45EE-9014-DB57E5BF94F8}" dt="2021-08-25T23:43:25.315" v="4" actId="14100"/>
          <ac:spMkLst>
            <pc:docMk/>
            <pc:sldMk cId="495918903" sldId="261"/>
            <ac:spMk id="16" creationId="{FD7178D0-839C-4B3A-BBB6-CA6BD17E544D}"/>
          </ac:spMkLst>
        </pc:spChg>
        <pc:spChg chg="add mod">
          <ac:chgData name="Muhammad Usman Tariq" userId="03ce5289-4d1e-4316-81c6-77963b418d72" providerId="ADAL" clId="{00010A79-167B-45EE-9014-DB57E5BF94F8}" dt="2021-08-25T23:44:46.078" v="21" actId="20577"/>
          <ac:spMkLst>
            <pc:docMk/>
            <pc:sldMk cId="495918903" sldId="261"/>
            <ac:spMk id="22" creationId="{8E44EE18-2868-483F-ADD1-39539104437F}"/>
          </ac:spMkLst>
        </pc:spChg>
        <pc:spChg chg="add mod">
          <ac:chgData name="Muhammad Usman Tariq" userId="03ce5289-4d1e-4316-81c6-77963b418d72" providerId="ADAL" clId="{00010A79-167B-45EE-9014-DB57E5BF94F8}" dt="2021-08-25T23:44:43.556" v="19" actId="20577"/>
          <ac:spMkLst>
            <pc:docMk/>
            <pc:sldMk cId="495918903" sldId="261"/>
            <ac:spMk id="23" creationId="{B17A3EDE-7CF7-442E-85E7-B00799417079}"/>
          </ac:spMkLst>
        </pc:spChg>
        <pc:cxnChg chg="add mod">
          <ac:chgData name="Muhammad Usman Tariq" userId="03ce5289-4d1e-4316-81c6-77963b418d72" providerId="ADAL" clId="{00010A79-167B-45EE-9014-DB57E5BF94F8}" dt="2021-08-25T23:43:05.346" v="1" actId="13822"/>
          <ac:cxnSpMkLst>
            <pc:docMk/>
            <pc:sldMk cId="495918903" sldId="261"/>
            <ac:cxnSpMk id="4" creationId="{33ADE680-663D-4BBF-B5A9-D5803D42B148}"/>
          </ac:cxnSpMkLst>
        </pc:cxnChg>
        <pc:cxnChg chg="add mod">
          <ac:chgData name="Muhammad Usman Tariq" userId="03ce5289-4d1e-4316-81c6-77963b418d72" providerId="ADAL" clId="{00010A79-167B-45EE-9014-DB57E5BF94F8}" dt="2021-08-25T23:43:40.389" v="6" actId="13822"/>
          <ac:cxnSpMkLst>
            <pc:docMk/>
            <pc:sldMk cId="495918903" sldId="261"/>
            <ac:cxnSpMk id="8" creationId="{7660991C-3D0D-4AA2-A204-E24DDB951A53}"/>
          </ac:cxnSpMkLst>
        </pc:cxnChg>
        <pc:cxnChg chg="add mod">
          <ac:chgData name="Muhammad Usman Tariq" userId="03ce5289-4d1e-4316-81c6-77963b418d72" providerId="ADAL" clId="{00010A79-167B-45EE-9014-DB57E5BF94F8}" dt="2021-08-25T23:43:53.008" v="8" actId="13822"/>
          <ac:cxnSpMkLst>
            <pc:docMk/>
            <pc:sldMk cId="495918903" sldId="261"/>
            <ac:cxnSpMk id="11" creationId="{33ED33C4-7344-4084-898C-ABCFDC7635F0}"/>
          </ac:cxnSpMkLst>
        </pc:cxnChg>
      </pc:sldChg>
      <pc:sldChg chg="addSp delSp modSp mod">
        <pc:chgData name="Muhammad Usman Tariq" userId="03ce5289-4d1e-4316-81c6-77963b418d72" providerId="ADAL" clId="{00010A79-167B-45EE-9014-DB57E5BF94F8}" dt="2021-08-26T00:47:27.262" v="66" actId="20577"/>
        <pc:sldMkLst>
          <pc:docMk/>
          <pc:sldMk cId="1405023871" sldId="264"/>
        </pc:sldMkLst>
        <pc:spChg chg="add mod">
          <ac:chgData name="Muhammad Usman Tariq" userId="03ce5289-4d1e-4316-81c6-77963b418d72" providerId="ADAL" clId="{00010A79-167B-45EE-9014-DB57E5BF94F8}" dt="2021-08-26T00:46:45.455" v="42" actId="1076"/>
          <ac:spMkLst>
            <pc:docMk/>
            <pc:sldMk cId="1405023871" sldId="264"/>
            <ac:spMk id="6" creationId="{8F0DE333-0D7C-4DA2-AD5F-175EDA7F5855}"/>
          </ac:spMkLst>
        </pc:spChg>
        <pc:spChg chg="add mod">
          <ac:chgData name="Muhammad Usman Tariq" userId="03ce5289-4d1e-4316-81c6-77963b418d72" providerId="ADAL" clId="{00010A79-167B-45EE-9014-DB57E5BF94F8}" dt="2021-08-26T00:47:00.175" v="52" actId="20577"/>
          <ac:spMkLst>
            <pc:docMk/>
            <pc:sldMk cId="1405023871" sldId="264"/>
            <ac:spMk id="7" creationId="{994FC885-72FA-4717-87C0-C4799C6D65CB}"/>
          </ac:spMkLst>
        </pc:spChg>
        <pc:spChg chg="add mod">
          <ac:chgData name="Muhammad Usman Tariq" userId="03ce5289-4d1e-4316-81c6-77963b418d72" providerId="ADAL" clId="{00010A79-167B-45EE-9014-DB57E5BF94F8}" dt="2021-08-26T00:47:27.262" v="66" actId="20577"/>
          <ac:spMkLst>
            <pc:docMk/>
            <pc:sldMk cId="1405023871" sldId="264"/>
            <ac:spMk id="8" creationId="{5794A279-A26B-4AE1-B5EF-FA7611DBEE95}"/>
          </ac:spMkLst>
        </pc:spChg>
        <pc:picChg chg="add mod">
          <ac:chgData name="Muhammad Usman Tariq" userId="03ce5289-4d1e-4316-81c6-77963b418d72" providerId="ADAL" clId="{00010A79-167B-45EE-9014-DB57E5BF94F8}" dt="2021-08-26T00:46:11.034" v="28" actId="1076"/>
          <ac:picMkLst>
            <pc:docMk/>
            <pc:sldMk cId="1405023871" sldId="264"/>
            <ac:picMk id="4" creationId="{EB97AA09-192D-42CE-97DA-1507D7BCB55B}"/>
          </ac:picMkLst>
        </pc:picChg>
        <pc:picChg chg="del">
          <ac:chgData name="Muhammad Usman Tariq" userId="03ce5289-4d1e-4316-81c6-77963b418d72" providerId="ADAL" clId="{00010A79-167B-45EE-9014-DB57E5BF94F8}" dt="2021-08-26T00:45:55.789" v="24" actId="478"/>
          <ac:picMkLst>
            <pc:docMk/>
            <pc:sldMk cId="1405023871" sldId="264"/>
            <ac:picMk id="5" creationId="{42D620C7-5C35-4DE8-9C57-AD631E13BB75}"/>
          </ac:picMkLst>
        </pc:picChg>
      </pc:sldChg>
      <pc:sldChg chg="add">
        <pc:chgData name="Muhammad Usman Tariq" userId="03ce5289-4d1e-4316-81c6-77963b418d72" providerId="ADAL" clId="{00010A79-167B-45EE-9014-DB57E5BF94F8}" dt="2021-08-26T00:45:45.759" v="23"/>
        <pc:sldMkLst>
          <pc:docMk/>
          <pc:sldMk cId="2505558454" sldId="266"/>
        </pc:sldMkLst>
      </pc:sldChg>
      <pc:sldChg chg="new del">
        <pc:chgData name="Muhammad Usman Tariq" userId="03ce5289-4d1e-4316-81c6-77963b418d72" providerId="ADAL" clId="{00010A79-167B-45EE-9014-DB57E5BF94F8}" dt="2021-08-30T04:39:24.239" v="68" actId="680"/>
        <pc:sldMkLst>
          <pc:docMk/>
          <pc:sldMk cId="458496838" sldId="267"/>
        </pc:sldMkLst>
      </pc:sldChg>
      <pc:sldChg chg="addSp delSp modSp new mod">
        <pc:chgData name="Muhammad Usman Tariq" userId="03ce5289-4d1e-4316-81c6-77963b418d72" providerId="ADAL" clId="{00010A79-167B-45EE-9014-DB57E5BF94F8}" dt="2021-08-30T04:54:16.683" v="127" actId="1076"/>
        <pc:sldMkLst>
          <pc:docMk/>
          <pc:sldMk cId="3446080782" sldId="267"/>
        </pc:sldMkLst>
        <pc:spChg chg="del">
          <ac:chgData name="Muhammad Usman Tariq" userId="03ce5289-4d1e-4316-81c6-77963b418d72" providerId="ADAL" clId="{00010A79-167B-45EE-9014-DB57E5BF94F8}" dt="2021-08-30T04:39:30.590" v="70" actId="478"/>
          <ac:spMkLst>
            <pc:docMk/>
            <pc:sldMk cId="3446080782" sldId="267"/>
            <ac:spMk id="2" creationId="{16D853F6-D4CC-4327-80E8-1D137B3C58EA}"/>
          </ac:spMkLst>
        </pc:spChg>
        <pc:spChg chg="add mod">
          <ac:chgData name="Muhammad Usman Tariq" userId="03ce5289-4d1e-4316-81c6-77963b418d72" providerId="ADAL" clId="{00010A79-167B-45EE-9014-DB57E5BF94F8}" dt="2021-08-30T04:41:40.474" v="97" actId="20577"/>
          <ac:spMkLst>
            <pc:docMk/>
            <pc:sldMk cId="3446080782" sldId="267"/>
            <ac:spMk id="5" creationId="{CA597B09-62F0-45F7-AF7C-8CB7D5095AF7}"/>
          </ac:spMkLst>
        </pc:spChg>
        <pc:spChg chg="add mod">
          <ac:chgData name="Muhammad Usman Tariq" userId="03ce5289-4d1e-4316-81c6-77963b418d72" providerId="ADAL" clId="{00010A79-167B-45EE-9014-DB57E5BF94F8}" dt="2021-08-30T04:54:16.683" v="127" actId="1076"/>
          <ac:spMkLst>
            <pc:docMk/>
            <pc:sldMk cId="3446080782" sldId="267"/>
            <ac:spMk id="6" creationId="{D916C004-B69C-4DE3-B30E-1FDC9DFF22A6}"/>
          </ac:spMkLst>
        </pc:spChg>
        <pc:spChg chg="add mod">
          <ac:chgData name="Muhammad Usman Tariq" userId="03ce5289-4d1e-4316-81c6-77963b418d72" providerId="ADAL" clId="{00010A79-167B-45EE-9014-DB57E5BF94F8}" dt="2021-08-30T04:43:13.316" v="109" actId="1076"/>
          <ac:spMkLst>
            <pc:docMk/>
            <pc:sldMk cId="3446080782" sldId="267"/>
            <ac:spMk id="7" creationId="{F919B3CE-B960-46D5-BBDE-052DA886B4BC}"/>
          </ac:spMkLst>
        </pc:spChg>
        <pc:spChg chg="add mod">
          <ac:chgData name="Muhammad Usman Tariq" userId="03ce5289-4d1e-4316-81c6-77963b418d72" providerId="ADAL" clId="{00010A79-167B-45EE-9014-DB57E5BF94F8}" dt="2021-08-30T04:43:24.040" v="114" actId="20577"/>
          <ac:spMkLst>
            <pc:docMk/>
            <pc:sldMk cId="3446080782" sldId="267"/>
            <ac:spMk id="8" creationId="{6198BEC0-3BD1-43C1-B09B-2037965840A3}"/>
          </ac:spMkLst>
        </pc:spChg>
        <pc:spChg chg="add mod">
          <ac:chgData name="Muhammad Usman Tariq" userId="03ce5289-4d1e-4316-81c6-77963b418d72" providerId="ADAL" clId="{00010A79-167B-45EE-9014-DB57E5BF94F8}" dt="2021-08-30T04:43:49.232" v="119" actId="1076"/>
          <ac:spMkLst>
            <pc:docMk/>
            <pc:sldMk cId="3446080782" sldId="267"/>
            <ac:spMk id="9" creationId="{8789E5F7-6749-4857-B294-2A82BC3DD8A7}"/>
          </ac:spMkLst>
        </pc:spChg>
        <pc:spChg chg="add mod">
          <ac:chgData name="Muhammad Usman Tariq" userId="03ce5289-4d1e-4316-81c6-77963b418d72" providerId="ADAL" clId="{00010A79-167B-45EE-9014-DB57E5BF94F8}" dt="2021-08-30T04:44:02.464" v="124" actId="20577"/>
          <ac:spMkLst>
            <pc:docMk/>
            <pc:sldMk cId="3446080782" sldId="267"/>
            <ac:spMk id="10" creationId="{85A6F379-84B1-4DD2-BD36-CF3EE98936CE}"/>
          </ac:spMkLst>
        </pc:spChg>
        <pc:picChg chg="add mod">
          <ac:chgData name="Muhammad Usman Tariq" userId="03ce5289-4d1e-4316-81c6-77963b418d72" providerId="ADAL" clId="{00010A79-167B-45EE-9014-DB57E5BF94F8}" dt="2021-08-30T04:40:34.279" v="83" actId="1076"/>
          <ac:picMkLst>
            <pc:docMk/>
            <pc:sldMk cId="3446080782" sldId="267"/>
            <ac:picMk id="4" creationId="{8776BC85-1396-4E93-9A8E-C34D567B361A}"/>
          </ac:picMkLst>
        </pc:picChg>
      </pc:sldChg>
    </pc:docChg>
  </pc:docChgLst>
  <pc:docChgLst>
    <pc:chgData name="Muhammad Usman Tariq" userId="03ce5289-4d1e-4316-81c6-77963b418d72" providerId="ADAL" clId="{1E2238AA-55EC-4C03-8C1C-6BD5F7C01D6F}"/>
    <pc:docChg chg="undo redo custSel addSld modSld sldOrd">
      <pc:chgData name="Muhammad Usman Tariq" userId="03ce5289-4d1e-4316-81c6-77963b418d72" providerId="ADAL" clId="{1E2238AA-55EC-4C03-8C1C-6BD5F7C01D6F}" dt="2021-08-20T03:41:24.095" v="1367" actId="14100"/>
      <pc:docMkLst>
        <pc:docMk/>
      </pc:docMkLst>
      <pc:sldChg chg="modSp new mod">
        <pc:chgData name="Muhammad Usman Tariq" userId="03ce5289-4d1e-4316-81c6-77963b418d72" providerId="ADAL" clId="{1E2238AA-55EC-4C03-8C1C-6BD5F7C01D6F}" dt="2021-08-18T02:43:16.561" v="42" actId="20577"/>
        <pc:sldMkLst>
          <pc:docMk/>
          <pc:sldMk cId="2700437164" sldId="256"/>
        </pc:sldMkLst>
        <pc:spChg chg="mod">
          <ac:chgData name="Muhammad Usman Tariq" userId="03ce5289-4d1e-4316-81c6-77963b418d72" providerId="ADAL" clId="{1E2238AA-55EC-4C03-8C1C-6BD5F7C01D6F}" dt="2021-08-18T02:43:06.915" v="20" actId="20577"/>
          <ac:spMkLst>
            <pc:docMk/>
            <pc:sldMk cId="2700437164" sldId="256"/>
            <ac:spMk id="2" creationId="{31D97D53-33ED-432C-A815-6D718233796C}"/>
          </ac:spMkLst>
        </pc:spChg>
        <pc:spChg chg="mod">
          <ac:chgData name="Muhammad Usman Tariq" userId="03ce5289-4d1e-4316-81c6-77963b418d72" providerId="ADAL" clId="{1E2238AA-55EC-4C03-8C1C-6BD5F7C01D6F}" dt="2021-08-18T02:43:16.561" v="42" actId="20577"/>
          <ac:spMkLst>
            <pc:docMk/>
            <pc:sldMk cId="2700437164" sldId="256"/>
            <ac:spMk id="3" creationId="{F705DE93-DCCD-4564-BAA3-655C9D83320C}"/>
          </ac:spMkLst>
        </pc:spChg>
      </pc:sldChg>
      <pc:sldChg chg="addSp delSp modSp new mod ord">
        <pc:chgData name="Muhammad Usman Tariq" userId="03ce5289-4d1e-4316-81c6-77963b418d72" providerId="ADAL" clId="{1E2238AA-55EC-4C03-8C1C-6BD5F7C01D6F}" dt="2021-08-20T03:41:24.095" v="1367" actId="14100"/>
        <pc:sldMkLst>
          <pc:docMk/>
          <pc:sldMk cId="3364857209" sldId="257"/>
        </pc:sldMkLst>
        <pc:spChg chg="mod">
          <ac:chgData name="Muhammad Usman Tariq" userId="03ce5289-4d1e-4316-81c6-77963b418d72" providerId="ADAL" clId="{1E2238AA-55EC-4C03-8C1C-6BD5F7C01D6F}" dt="2021-08-18T02:44:08.786" v="98" actId="14100"/>
          <ac:spMkLst>
            <pc:docMk/>
            <pc:sldMk cId="3364857209" sldId="257"/>
            <ac:spMk id="2" creationId="{EDD8D71D-F75E-4E1B-B133-00FD006678FA}"/>
          </ac:spMkLst>
        </pc:spChg>
        <pc:spChg chg="add del mod">
          <ac:chgData name="Muhammad Usman Tariq" userId="03ce5289-4d1e-4316-81c6-77963b418d72" providerId="ADAL" clId="{1E2238AA-55EC-4C03-8C1C-6BD5F7C01D6F}" dt="2021-08-20T03:15:03.502" v="1082" actId="478"/>
          <ac:spMkLst>
            <pc:docMk/>
            <pc:sldMk cId="3364857209" sldId="257"/>
            <ac:spMk id="5" creationId="{8E947E1A-1F58-4E87-9C09-B29EF671CC6B}"/>
          </ac:spMkLst>
        </pc:spChg>
        <pc:spChg chg="add mod">
          <ac:chgData name="Muhammad Usman Tariq" userId="03ce5289-4d1e-4316-81c6-77963b418d72" providerId="ADAL" clId="{1E2238AA-55EC-4C03-8C1C-6BD5F7C01D6F}" dt="2021-08-20T03:37:02.503" v="1307" actId="1036"/>
          <ac:spMkLst>
            <pc:docMk/>
            <pc:sldMk cId="3364857209" sldId="257"/>
            <ac:spMk id="18" creationId="{1A63C70C-F645-4DAE-9D52-9E557BFE4695}"/>
          </ac:spMkLst>
        </pc:spChg>
        <pc:spChg chg="mod">
          <ac:chgData name="Muhammad Usman Tariq" userId="03ce5289-4d1e-4316-81c6-77963b418d72" providerId="ADAL" clId="{1E2238AA-55EC-4C03-8C1C-6BD5F7C01D6F}" dt="2021-08-20T03:14:59.877" v="1081"/>
          <ac:spMkLst>
            <pc:docMk/>
            <pc:sldMk cId="3364857209" sldId="257"/>
            <ac:spMk id="24" creationId="{0E3E32F2-E0EC-4B55-BC72-DBE187B9BA83}"/>
          </ac:spMkLst>
        </pc:spChg>
        <pc:spChg chg="mod">
          <ac:chgData name="Muhammad Usman Tariq" userId="03ce5289-4d1e-4316-81c6-77963b418d72" providerId="ADAL" clId="{1E2238AA-55EC-4C03-8C1C-6BD5F7C01D6F}" dt="2021-08-20T03:14:59.877" v="1081"/>
          <ac:spMkLst>
            <pc:docMk/>
            <pc:sldMk cId="3364857209" sldId="257"/>
            <ac:spMk id="25" creationId="{32D81BC3-54AE-484E-A852-0C033181114B}"/>
          </ac:spMkLst>
        </pc:spChg>
        <pc:spChg chg="add mod">
          <ac:chgData name="Muhammad Usman Tariq" userId="03ce5289-4d1e-4316-81c6-77963b418d72" providerId="ADAL" clId="{1E2238AA-55EC-4C03-8C1C-6BD5F7C01D6F}" dt="2021-08-20T03:40:37.187" v="1362" actId="14100"/>
          <ac:spMkLst>
            <pc:docMk/>
            <pc:sldMk cId="3364857209" sldId="257"/>
            <ac:spMk id="27" creationId="{9AAFCA83-2232-43EF-B256-EEE032F23D34}"/>
          </ac:spMkLst>
        </pc:spChg>
        <pc:spChg chg="mod">
          <ac:chgData name="Muhammad Usman Tariq" userId="03ce5289-4d1e-4316-81c6-77963b418d72" providerId="ADAL" clId="{1E2238AA-55EC-4C03-8C1C-6BD5F7C01D6F}" dt="2021-08-20T03:14:59.877" v="1081"/>
          <ac:spMkLst>
            <pc:docMk/>
            <pc:sldMk cId="3364857209" sldId="257"/>
            <ac:spMk id="28" creationId="{1BA279CB-1688-4E18-99B3-AC8D78A925F5}"/>
          </ac:spMkLst>
        </pc:spChg>
        <pc:spChg chg="mod">
          <ac:chgData name="Muhammad Usman Tariq" userId="03ce5289-4d1e-4316-81c6-77963b418d72" providerId="ADAL" clId="{1E2238AA-55EC-4C03-8C1C-6BD5F7C01D6F}" dt="2021-08-20T03:14:59.877" v="1081"/>
          <ac:spMkLst>
            <pc:docMk/>
            <pc:sldMk cId="3364857209" sldId="257"/>
            <ac:spMk id="30" creationId="{9371F5B6-D4E8-4C12-B5C4-3E9B8AF49339}"/>
          </ac:spMkLst>
        </pc:spChg>
        <pc:spChg chg="mod">
          <ac:chgData name="Muhammad Usman Tariq" userId="03ce5289-4d1e-4316-81c6-77963b418d72" providerId="ADAL" clId="{1E2238AA-55EC-4C03-8C1C-6BD5F7C01D6F}" dt="2021-08-20T03:14:59.877" v="1081"/>
          <ac:spMkLst>
            <pc:docMk/>
            <pc:sldMk cId="3364857209" sldId="257"/>
            <ac:spMk id="32" creationId="{BE86736D-C47A-4212-BD9B-7D2DD2367AC9}"/>
          </ac:spMkLst>
        </pc:spChg>
        <pc:spChg chg="add mod">
          <ac:chgData name="Muhammad Usman Tariq" userId="03ce5289-4d1e-4316-81c6-77963b418d72" providerId="ADAL" clId="{1E2238AA-55EC-4C03-8C1C-6BD5F7C01D6F}" dt="2021-08-20T03:41:24.095" v="1367" actId="14100"/>
          <ac:spMkLst>
            <pc:docMk/>
            <pc:sldMk cId="3364857209" sldId="257"/>
            <ac:spMk id="35" creationId="{A5F8A1F2-A71D-4DAE-9145-AF4A0E42EC88}"/>
          </ac:spMkLst>
        </pc:spChg>
        <pc:spChg chg="add mod">
          <ac:chgData name="Muhammad Usman Tariq" userId="03ce5289-4d1e-4316-81c6-77963b418d72" providerId="ADAL" clId="{1E2238AA-55EC-4C03-8C1C-6BD5F7C01D6F}" dt="2021-08-20T03:41:06.988" v="1365" actId="1076"/>
          <ac:spMkLst>
            <pc:docMk/>
            <pc:sldMk cId="3364857209" sldId="257"/>
            <ac:spMk id="36" creationId="{8211CE96-13CC-42DC-B3EB-F47F1B5F5003}"/>
          </ac:spMkLst>
        </pc:spChg>
        <pc:spChg chg="add mod">
          <ac:chgData name="Muhammad Usman Tariq" userId="03ce5289-4d1e-4316-81c6-77963b418d72" providerId="ADAL" clId="{1E2238AA-55EC-4C03-8C1C-6BD5F7C01D6F}" dt="2021-08-20T03:40:14.409" v="1360" actId="1076"/>
          <ac:spMkLst>
            <pc:docMk/>
            <pc:sldMk cId="3364857209" sldId="257"/>
            <ac:spMk id="37" creationId="{83ACE920-DF24-48FC-8E68-B83E94C279EC}"/>
          </ac:spMkLst>
        </pc:spChg>
        <pc:grpChg chg="add mod">
          <ac:chgData name="Muhammad Usman Tariq" userId="03ce5289-4d1e-4316-81c6-77963b418d72" providerId="ADAL" clId="{1E2238AA-55EC-4C03-8C1C-6BD5F7C01D6F}" dt="2021-08-20T03:15:21.960" v="1092" actId="1076"/>
          <ac:grpSpMkLst>
            <pc:docMk/>
            <pc:sldMk cId="3364857209" sldId="257"/>
            <ac:grpSpMk id="23" creationId="{08259667-D6EB-4E8A-9FB8-120A71DAE022}"/>
          </ac:grpSpMkLst>
        </pc:grpChg>
        <pc:picChg chg="add del mod">
          <ac:chgData name="Muhammad Usman Tariq" userId="03ce5289-4d1e-4316-81c6-77963b418d72" providerId="ADAL" clId="{1E2238AA-55EC-4C03-8C1C-6BD5F7C01D6F}" dt="2021-08-20T03:07:03.809" v="960" actId="478"/>
          <ac:picMkLst>
            <pc:docMk/>
            <pc:sldMk cId="3364857209" sldId="257"/>
            <ac:picMk id="4" creationId="{72480035-59F2-4973-9C0D-637BAAEE1133}"/>
          </ac:picMkLst>
        </pc:picChg>
        <pc:picChg chg="add del mod">
          <ac:chgData name="Muhammad Usman Tariq" userId="03ce5289-4d1e-4316-81c6-77963b418d72" providerId="ADAL" clId="{1E2238AA-55EC-4C03-8C1C-6BD5F7C01D6F}" dt="2021-08-20T03:07:41.832" v="970" actId="478"/>
          <ac:picMkLst>
            <pc:docMk/>
            <pc:sldMk cId="3364857209" sldId="257"/>
            <ac:picMk id="6" creationId="{58E46124-B5DC-431A-8AC7-D13072FC841F}"/>
          </ac:picMkLst>
        </pc:picChg>
        <pc:picChg chg="add del mod">
          <ac:chgData name="Muhammad Usman Tariq" userId="03ce5289-4d1e-4316-81c6-77963b418d72" providerId="ADAL" clId="{1E2238AA-55EC-4C03-8C1C-6BD5F7C01D6F}" dt="2021-08-20T03:37:18.051" v="1312" actId="21"/>
          <ac:picMkLst>
            <pc:docMk/>
            <pc:sldMk cId="3364857209" sldId="257"/>
            <ac:picMk id="10" creationId="{1055001C-05FC-499E-B2C7-1E32E4E7A025}"/>
          </ac:picMkLst>
        </pc:picChg>
        <pc:picChg chg="add del mod">
          <ac:chgData name="Muhammad Usman Tariq" userId="03ce5289-4d1e-4316-81c6-77963b418d72" providerId="ADAL" clId="{1E2238AA-55EC-4C03-8C1C-6BD5F7C01D6F}" dt="2021-08-18T02:54:37.433" v="236" actId="478"/>
          <ac:picMkLst>
            <pc:docMk/>
            <pc:sldMk cId="3364857209" sldId="257"/>
            <ac:picMk id="13" creationId="{2805F5CB-AF42-4FF9-8009-B3038DF04F42}"/>
          </ac:picMkLst>
        </pc:picChg>
        <pc:picChg chg="add del mod">
          <ac:chgData name="Muhammad Usman Tariq" userId="03ce5289-4d1e-4316-81c6-77963b418d72" providerId="ADAL" clId="{1E2238AA-55EC-4C03-8C1C-6BD5F7C01D6F}" dt="2021-08-18T02:54:59.137" v="242" actId="478"/>
          <ac:picMkLst>
            <pc:docMk/>
            <pc:sldMk cId="3364857209" sldId="257"/>
            <ac:picMk id="15" creationId="{E7626D41-9678-4D9F-8209-C3A0C4DC233F}"/>
          </ac:picMkLst>
        </pc:picChg>
        <pc:picChg chg="add del mod">
          <ac:chgData name="Muhammad Usman Tariq" userId="03ce5289-4d1e-4316-81c6-77963b418d72" providerId="ADAL" clId="{1E2238AA-55EC-4C03-8C1C-6BD5F7C01D6F}" dt="2021-08-20T03:07:07.771" v="962" actId="478"/>
          <ac:picMkLst>
            <pc:docMk/>
            <pc:sldMk cId="3364857209" sldId="257"/>
            <ac:picMk id="17" creationId="{CD1DBB49-60E5-4E61-B84A-A83F23B78902}"/>
          </ac:picMkLst>
        </pc:picChg>
        <pc:picChg chg="add mod ord">
          <ac:chgData name="Muhammad Usman Tariq" userId="03ce5289-4d1e-4316-81c6-77963b418d72" providerId="ADAL" clId="{1E2238AA-55EC-4C03-8C1C-6BD5F7C01D6F}" dt="2021-08-20T03:15:10.239" v="1087" actId="1076"/>
          <ac:picMkLst>
            <pc:docMk/>
            <pc:sldMk cId="3364857209" sldId="257"/>
            <ac:picMk id="21" creationId="{4B0E2B2D-B673-4003-8E4F-829EC7361F48}"/>
          </ac:picMkLst>
        </pc:picChg>
        <pc:picChg chg="add del mod">
          <ac:chgData name="Muhammad Usman Tariq" userId="03ce5289-4d1e-4316-81c6-77963b418d72" providerId="ADAL" clId="{1E2238AA-55EC-4C03-8C1C-6BD5F7C01D6F}" dt="2021-08-18T03:03:09.115" v="257" actId="478"/>
          <ac:picMkLst>
            <pc:docMk/>
            <pc:sldMk cId="3364857209" sldId="257"/>
            <ac:picMk id="24" creationId="{E5B0EF38-ABC7-4929-9E10-4BACB452A9FB}"/>
          </ac:picMkLst>
        </pc:picChg>
        <pc:picChg chg="add del mod ord">
          <ac:chgData name="Muhammad Usman Tariq" userId="03ce5289-4d1e-4316-81c6-77963b418d72" providerId="ADAL" clId="{1E2238AA-55EC-4C03-8C1C-6BD5F7C01D6F}" dt="2021-08-20T03:07:05.805" v="961" actId="478"/>
          <ac:picMkLst>
            <pc:docMk/>
            <pc:sldMk cId="3364857209" sldId="257"/>
            <ac:picMk id="26" creationId="{4A74AF47-6B02-4770-B321-2A61BE4AB0D6}"/>
          </ac:picMkLst>
        </pc:picChg>
        <pc:picChg chg="add mod ord">
          <ac:chgData name="Muhammad Usman Tariq" userId="03ce5289-4d1e-4316-81c6-77963b418d72" providerId="ADAL" clId="{1E2238AA-55EC-4C03-8C1C-6BD5F7C01D6F}" dt="2021-08-20T03:38:40.183" v="1339" actId="1076"/>
          <ac:picMkLst>
            <pc:docMk/>
            <pc:sldMk cId="3364857209" sldId="257"/>
            <ac:picMk id="33" creationId="{73169254-9233-4F4A-81B8-4140B90F656E}"/>
          </ac:picMkLst>
        </pc:picChg>
        <pc:picChg chg="add mod ord">
          <ac:chgData name="Muhammad Usman Tariq" userId="03ce5289-4d1e-4316-81c6-77963b418d72" providerId="ADAL" clId="{1E2238AA-55EC-4C03-8C1C-6BD5F7C01D6F}" dt="2021-08-20T03:39:40.351" v="1356" actId="1076"/>
          <ac:picMkLst>
            <pc:docMk/>
            <pc:sldMk cId="3364857209" sldId="257"/>
            <ac:picMk id="38" creationId="{61ACFA89-AC1D-4F3D-9896-3E59C8D26D58}"/>
          </ac:picMkLst>
        </pc:picChg>
        <pc:cxnChg chg="add del mod">
          <ac:chgData name="Muhammad Usman Tariq" userId="03ce5289-4d1e-4316-81c6-77963b418d72" providerId="ADAL" clId="{1E2238AA-55EC-4C03-8C1C-6BD5F7C01D6F}" dt="2021-08-20T03:15:16.108" v="1091" actId="478"/>
          <ac:cxnSpMkLst>
            <pc:docMk/>
            <pc:sldMk cId="3364857209" sldId="257"/>
            <ac:cxnSpMk id="7" creationId="{6B64027A-862A-4E22-90E2-85BD9E240BE9}"/>
          </ac:cxnSpMkLst>
        </pc:cxnChg>
        <pc:cxnChg chg="add del mod">
          <ac:chgData name="Muhammad Usman Tariq" userId="03ce5289-4d1e-4316-81c6-77963b418d72" providerId="ADAL" clId="{1E2238AA-55EC-4C03-8C1C-6BD5F7C01D6F}" dt="2021-08-20T03:15:05.688" v="1084" actId="478"/>
          <ac:cxnSpMkLst>
            <pc:docMk/>
            <pc:sldMk cId="3364857209" sldId="257"/>
            <ac:cxnSpMk id="9" creationId="{1DA50D1D-6D26-4DE8-B721-6431AB894EBA}"/>
          </ac:cxnSpMkLst>
        </pc:cxnChg>
        <pc:cxnChg chg="add del mod">
          <ac:chgData name="Muhammad Usman Tariq" userId="03ce5289-4d1e-4316-81c6-77963b418d72" providerId="ADAL" clId="{1E2238AA-55EC-4C03-8C1C-6BD5F7C01D6F}" dt="2021-08-20T03:15:04.470" v="1083" actId="478"/>
          <ac:cxnSpMkLst>
            <pc:docMk/>
            <pc:sldMk cId="3364857209" sldId="257"/>
            <ac:cxnSpMk id="11" creationId="{62901DC5-95F2-4C2D-ACBF-06E5B790E647}"/>
          </ac:cxnSpMkLst>
        </pc:cxnChg>
        <pc:cxnChg chg="add mod">
          <ac:chgData name="Muhammad Usman Tariq" userId="03ce5289-4d1e-4316-81c6-77963b418d72" providerId="ADAL" clId="{1E2238AA-55EC-4C03-8C1C-6BD5F7C01D6F}" dt="2021-08-20T03:38:47.256" v="1341" actId="14100"/>
          <ac:cxnSpMkLst>
            <pc:docMk/>
            <pc:sldMk cId="3364857209" sldId="257"/>
            <ac:cxnSpMk id="20" creationId="{01D50E07-3F5B-4380-B793-EDD337E0B1B4}"/>
          </ac:cxnSpMkLst>
        </pc:cxnChg>
        <pc:cxnChg chg="add mod">
          <ac:chgData name="Muhammad Usman Tariq" userId="03ce5289-4d1e-4316-81c6-77963b418d72" providerId="ADAL" clId="{1E2238AA-55EC-4C03-8C1C-6BD5F7C01D6F}" dt="2021-08-20T03:38:50.997" v="1342" actId="14100"/>
          <ac:cxnSpMkLst>
            <pc:docMk/>
            <pc:sldMk cId="3364857209" sldId="257"/>
            <ac:cxnSpMk id="22" creationId="{B4827745-2CFD-4CB4-9203-AD54138E6697}"/>
          </ac:cxnSpMkLst>
        </pc:cxnChg>
        <pc:cxnChg chg="add mod">
          <ac:chgData name="Muhammad Usman Tariq" userId="03ce5289-4d1e-4316-81c6-77963b418d72" providerId="ADAL" clId="{1E2238AA-55EC-4C03-8C1C-6BD5F7C01D6F}" dt="2021-08-20T03:40:41.406" v="1363" actId="14100"/>
          <ac:cxnSpMkLst>
            <pc:docMk/>
            <pc:sldMk cId="3364857209" sldId="257"/>
            <ac:cxnSpMk id="29" creationId="{4AFC2137-2E8B-4A11-82B8-D0E04820B80F}"/>
          </ac:cxnSpMkLst>
        </pc:cxnChg>
        <pc:cxnChg chg="add mod">
          <ac:chgData name="Muhammad Usman Tariq" userId="03ce5289-4d1e-4316-81c6-77963b418d72" providerId="ADAL" clId="{1E2238AA-55EC-4C03-8C1C-6BD5F7C01D6F}" dt="2021-08-20T03:40:49.712" v="1364" actId="14100"/>
          <ac:cxnSpMkLst>
            <pc:docMk/>
            <pc:sldMk cId="3364857209" sldId="257"/>
            <ac:cxnSpMk id="31" creationId="{C04DA262-DD1B-4CAA-8E23-1413DDA2E836}"/>
          </ac:cxnSpMkLst>
        </pc:cxnChg>
      </pc:sldChg>
      <pc:sldChg chg="addSp delSp modSp mod">
        <pc:chgData name="Muhammad Usman Tariq" userId="03ce5289-4d1e-4316-81c6-77963b418d72" providerId="ADAL" clId="{1E2238AA-55EC-4C03-8C1C-6BD5F7C01D6F}" dt="2021-08-20T03:37:35.482" v="1317" actId="21"/>
        <pc:sldMkLst>
          <pc:docMk/>
          <pc:sldMk cId="4282255786" sldId="258"/>
        </pc:sldMkLst>
        <pc:spChg chg="mod">
          <ac:chgData name="Muhammad Usman Tariq" userId="03ce5289-4d1e-4316-81c6-77963b418d72" providerId="ADAL" clId="{1E2238AA-55EC-4C03-8C1C-6BD5F7C01D6F}" dt="2021-08-20T03:21:47.949" v="1098" actId="14100"/>
          <ac:spMkLst>
            <pc:docMk/>
            <pc:sldMk cId="4282255786" sldId="258"/>
            <ac:spMk id="2" creationId="{EDD8D71D-F75E-4E1B-B133-00FD006678FA}"/>
          </ac:spMkLst>
        </pc:spChg>
        <pc:spChg chg="del mod">
          <ac:chgData name="Muhammad Usman Tariq" userId="03ce5289-4d1e-4316-81c6-77963b418d72" providerId="ADAL" clId="{1E2238AA-55EC-4C03-8C1C-6BD5F7C01D6F}" dt="2021-08-20T03:21:16.604" v="1093" actId="478"/>
          <ac:spMkLst>
            <pc:docMk/>
            <pc:sldMk cId="4282255786" sldId="258"/>
            <ac:spMk id="5" creationId="{8E947E1A-1F58-4E87-9C09-B29EF671CC6B}"/>
          </ac:spMkLst>
        </pc:spChg>
        <pc:spChg chg="mod">
          <ac:chgData name="Muhammad Usman Tariq" userId="03ce5289-4d1e-4316-81c6-77963b418d72" providerId="ADAL" clId="{1E2238AA-55EC-4C03-8C1C-6BD5F7C01D6F}" dt="2021-08-19T20:54:34.301" v="932" actId="14100"/>
          <ac:spMkLst>
            <pc:docMk/>
            <pc:sldMk cId="4282255786" sldId="258"/>
            <ac:spMk id="18" creationId="{1A63C70C-F645-4DAE-9D52-9E557BFE4695}"/>
          </ac:spMkLst>
        </pc:spChg>
        <pc:spChg chg="mod">
          <ac:chgData name="Muhammad Usman Tariq" userId="03ce5289-4d1e-4316-81c6-77963b418d72" providerId="ADAL" clId="{1E2238AA-55EC-4C03-8C1C-6BD5F7C01D6F}" dt="2021-08-19T20:49:26.820" v="898" actId="14100"/>
          <ac:spMkLst>
            <pc:docMk/>
            <pc:sldMk cId="4282255786" sldId="258"/>
            <ac:spMk id="27" creationId="{9AAFCA83-2232-43EF-B256-EEE032F23D34}"/>
          </ac:spMkLst>
        </pc:spChg>
        <pc:spChg chg="mod">
          <ac:chgData name="Muhammad Usman Tariq" userId="03ce5289-4d1e-4316-81c6-77963b418d72" providerId="ADAL" clId="{1E2238AA-55EC-4C03-8C1C-6BD5F7C01D6F}" dt="2021-08-20T03:21:41.437" v="1097" actId="14100"/>
          <ac:spMkLst>
            <pc:docMk/>
            <pc:sldMk cId="4282255786" sldId="258"/>
            <ac:spMk id="35" creationId="{A5F8A1F2-A71D-4DAE-9145-AF4A0E42EC88}"/>
          </ac:spMkLst>
        </pc:spChg>
        <pc:spChg chg="mod">
          <ac:chgData name="Muhammad Usman Tariq" userId="03ce5289-4d1e-4316-81c6-77963b418d72" providerId="ADAL" clId="{1E2238AA-55EC-4C03-8C1C-6BD5F7C01D6F}" dt="2021-08-19T20:59:57.733" v="952" actId="1076"/>
          <ac:spMkLst>
            <pc:docMk/>
            <pc:sldMk cId="4282255786" sldId="258"/>
            <ac:spMk id="36" creationId="{8211CE96-13CC-42DC-B3EB-F47F1B5F5003}"/>
          </ac:spMkLst>
        </pc:spChg>
        <pc:spChg chg="mod">
          <ac:chgData name="Muhammad Usman Tariq" userId="03ce5289-4d1e-4316-81c6-77963b418d72" providerId="ADAL" clId="{1E2238AA-55EC-4C03-8C1C-6BD5F7C01D6F}" dt="2021-08-19T21:00:07.837" v="955" actId="1076"/>
          <ac:spMkLst>
            <pc:docMk/>
            <pc:sldMk cId="4282255786" sldId="258"/>
            <ac:spMk id="37" creationId="{83ACE920-DF24-48FC-8E68-B83E94C279EC}"/>
          </ac:spMkLst>
        </pc:spChg>
        <pc:spChg chg="add mod ord">
          <ac:chgData name="Muhammad Usman Tariq" userId="03ce5289-4d1e-4316-81c6-77963b418d72" providerId="ADAL" clId="{1E2238AA-55EC-4C03-8C1C-6BD5F7C01D6F}" dt="2021-08-20T03:13:13.497" v="1073" actId="164"/>
          <ac:spMkLst>
            <pc:docMk/>
            <pc:sldMk cId="4282255786" sldId="258"/>
            <ac:spMk id="67" creationId="{DD7718E4-55E4-4ABE-A634-F74D79335758}"/>
          </ac:spMkLst>
        </pc:spChg>
        <pc:spChg chg="add mod ord">
          <ac:chgData name="Muhammad Usman Tariq" userId="03ce5289-4d1e-4316-81c6-77963b418d72" providerId="ADAL" clId="{1E2238AA-55EC-4C03-8C1C-6BD5F7C01D6F}" dt="2021-08-20T03:13:13.497" v="1073" actId="164"/>
          <ac:spMkLst>
            <pc:docMk/>
            <pc:sldMk cId="4282255786" sldId="258"/>
            <ac:spMk id="68" creationId="{526307C1-D12D-428D-A000-C08EDA5C0D47}"/>
          </ac:spMkLst>
        </pc:spChg>
        <pc:spChg chg="add mod ord">
          <ac:chgData name="Muhammad Usman Tariq" userId="03ce5289-4d1e-4316-81c6-77963b418d72" providerId="ADAL" clId="{1E2238AA-55EC-4C03-8C1C-6BD5F7C01D6F}" dt="2021-08-20T03:14:12.561" v="1078" actId="1076"/>
          <ac:spMkLst>
            <pc:docMk/>
            <pc:sldMk cId="4282255786" sldId="258"/>
            <ac:spMk id="69" creationId="{5FADF267-54CD-424B-AB2E-C3DC20D52AFC}"/>
          </ac:spMkLst>
        </pc:spChg>
        <pc:spChg chg="add mod ord">
          <ac:chgData name="Muhammad Usman Tariq" userId="03ce5289-4d1e-4316-81c6-77963b418d72" providerId="ADAL" clId="{1E2238AA-55EC-4C03-8C1C-6BD5F7C01D6F}" dt="2021-08-20T03:14:36.064" v="1080" actId="1076"/>
          <ac:spMkLst>
            <pc:docMk/>
            <pc:sldMk cId="4282255786" sldId="258"/>
            <ac:spMk id="70" creationId="{69ECCB2D-1F8A-4B46-8C81-DFCF8F9E8F4C}"/>
          </ac:spMkLst>
        </pc:spChg>
        <pc:spChg chg="add mod">
          <ac:chgData name="Muhammad Usman Tariq" userId="03ce5289-4d1e-4316-81c6-77963b418d72" providerId="ADAL" clId="{1E2238AA-55EC-4C03-8C1C-6BD5F7C01D6F}" dt="2021-08-20T03:13:13.497" v="1073" actId="164"/>
          <ac:spMkLst>
            <pc:docMk/>
            <pc:sldMk cId="4282255786" sldId="258"/>
            <ac:spMk id="71" creationId="{01B1FDDE-A5FD-489B-A2C7-85E0366660A3}"/>
          </ac:spMkLst>
        </pc:spChg>
        <pc:grpChg chg="add mod ord">
          <ac:chgData name="Muhammad Usman Tariq" userId="03ce5289-4d1e-4316-81c6-77963b418d72" providerId="ADAL" clId="{1E2238AA-55EC-4C03-8C1C-6BD5F7C01D6F}" dt="2021-08-20T03:12:47.156" v="1067" actId="164"/>
          <ac:grpSpMkLst>
            <pc:docMk/>
            <pc:sldMk cId="4282255786" sldId="258"/>
            <ac:grpSpMk id="72" creationId="{FC19185F-EDA1-4F65-9757-8522B0D504E4}"/>
          </ac:grpSpMkLst>
        </pc:grpChg>
        <pc:grpChg chg="add mod">
          <ac:chgData name="Muhammad Usman Tariq" userId="03ce5289-4d1e-4316-81c6-77963b418d72" providerId="ADAL" clId="{1E2238AA-55EC-4C03-8C1C-6BD5F7C01D6F}" dt="2021-08-20T03:13:33.313" v="1075" actId="14100"/>
          <ac:grpSpMkLst>
            <pc:docMk/>
            <pc:sldMk cId="4282255786" sldId="258"/>
            <ac:grpSpMk id="73" creationId="{B3393CF3-7729-429E-870E-C91642DF5E69}"/>
          </ac:grpSpMkLst>
        </pc:grpChg>
        <pc:picChg chg="add mod ord">
          <ac:chgData name="Muhammad Usman Tariq" userId="03ce5289-4d1e-4316-81c6-77963b418d72" providerId="ADAL" clId="{1E2238AA-55EC-4C03-8C1C-6BD5F7C01D6F}" dt="2021-08-19T20:48:39.199" v="895" actId="14100"/>
          <ac:picMkLst>
            <pc:docMk/>
            <pc:sldMk cId="4282255786" sldId="258"/>
            <ac:picMk id="4" creationId="{78C138B0-8358-4DD5-8724-D50110E5DA17}"/>
          </ac:picMkLst>
        </pc:picChg>
        <pc:picChg chg="del">
          <ac:chgData name="Muhammad Usman Tariq" userId="03ce5289-4d1e-4316-81c6-77963b418d72" providerId="ADAL" clId="{1E2238AA-55EC-4C03-8C1C-6BD5F7C01D6F}" dt="2021-08-19T20:00:48.048" v="682" actId="478"/>
          <ac:picMkLst>
            <pc:docMk/>
            <pc:sldMk cId="4282255786" sldId="258"/>
            <ac:picMk id="6" creationId="{2C112391-0F8F-4F4E-8D4E-A804E537BE1D}"/>
          </ac:picMkLst>
        </pc:picChg>
        <pc:picChg chg="del">
          <ac:chgData name="Muhammad Usman Tariq" userId="03ce5289-4d1e-4316-81c6-77963b418d72" providerId="ADAL" clId="{1E2238AA-55EC-4C03-8C1C-6BD5F7C01D6F}" dt="2021-08-19T20:41:49.007" v="788" actId="478"/>
          <ac:picMkLst>
            <pc:docMk/>
            <pc:sldMk cId="4282255786" sldId="258"/>
            <ac:picMk id="10" creationId="{0E9FFE8E-0DD2-4A72-86DB-076C65F024AE}"/>
          </ac:picMkLst>
        </pc:picChg>
        <pc:picChg chg="del">
          <ac:chgData name="Muhammad Usman Tariq" userId="03ce5289-4d1e-4316-81c6-77963b418d72" providerId="ADAL" clId="{1E2238AA-55EC-4C03-8C1C-6BD5F7C01D6F}" dt="2021-08-19T20:40:31.872" v="765" actId="478"/>
          <ac:picMkLst>
            <pc:docMk/>
            <pc:sldMk cId="4282255786" sldId="258"/>
            <ac:picMk id="15" creationId="{660F9B6C-0812-424E-87E0-F5171DE391F1}"/>
          </ac:picMkLst>
        </pc:picChg>
        <pc:picChg chg="add mod ord">
          <ac:chgData name="Muhammad Usman Tariq" userId="03ce5289-4d1e-4316-81c6-77963b418d72" providerId="ADAL" clId="{1E2238AA-55EC-4C03-8C1C-6BD5F7C01D6F}" dt="2021-08-19T20:59:52.612" v="951" actId="1076"/>
          <ac:picMkLst>
            <pc:docMk/>
            <pc:sldMk cId="4282255786" sldId="258"/>
            <ac:picMk id="19" creationId="{D10D8797-26FF-42A3-B956-329D65B86EEF}"/>
          </ac:picMkLst>
        </pc:picChg>
        <pc:picChg chg="add mod ord">
          <ac:chgData name="Muhammad Usman Tariq" userId="03ce5289-4d1e-4316-81c6-77963b418d72" providerId="ADAL" clId="{1E2238AA-55EC-4C03-8C1C-6BD5F7C01D6F}" dt="2021-08-19T20:59:48.648" v="950" actId="1076"/>
          <ac:picMkLst>
            <pc:docMk/>
            <pc:sldMk cId="4282255786" sldId="258"/>
            <ac:picMk id="30" creationId="{8329928D-F36C-46C2-949F-50AC1AC47FC9}"/>
          </ac:picMkLst>
        </pc:picChg>
        <pc:picChg chg="add del mod">
          <ac:chgData name="Muhammad Usman Tariq" userId="03ce5289-4d1e-4316-81c6-77963b418d72" providerId="ADAL" clId="{1E2238AA-55EC-4C03-8C1C-6BD5F7C01D6F}" dt="2021-08-19T20:59:43.053" v="949" actId="478"/>
          <ac:picMkLst>
            <pc:docMk/>
            <pc:sldMk cId="4282255786" sldId="258"/>
            <ac:picMk id="61" creationId="{7842652B-F25D-46E7-B965-27E5D5C43F87}"/>
          </ac:picMkLst>
        </pc:picChg>
        <pc:picChg chg="add del mod">
          <ac:chgData name="Muhammad Usman Tariq" userId="03ce5289-4d1e-4316-81c6-77963b418d72" providerId="ADAL" clId="{1E2238AA-55EC-4C03-8C1C-6BD5F7C01D6F}" dt="2021-08-20T03:07:38.841" v="969" actId="21"/>
          <ac:picMkLst>
            <pc:docMk/>
            <pc:sldMk cId="4282255786" sldId="258"/>
            <ac:picMk id="66" creationId="{F2F5E085-05BC-4101-AD7C-7186FED13450}"/>
          </ac:picMkLst>
        </pc:picChg>
        <pc:picChg chg="add del mod">
          <ac:chgData name="Muhammad Usman Tariq" userId="03ce5289-4d1e-4316-81c6-77963b418d72" providerId="ADAL" clId="{1E2238AA-55EC-4C03-8C1C-6BD5F7C01D6F}" dt="2021-08-20T03:37:35.482" v="1317" actId="21"/>
          <ac:picMkLst>
            <pc:docMk/>
            <pc:sldMk cId="4282255786" sldId="258"/>
            <ac:picMk id="74" creationId="{E5BEAEBD-9759-4EBC-9E52-1A05BF4461C9}"/>
          </ac:picMkLst>
        </pc:picChg>
        <pc:cxnChg chg="del">
          <ac:chgData name="Muhammad Usman Tariq" userId="03ce5289-4d1e-4316-81c6-77963b418d72" providerId="ADAL" clId="{1E2238AA-55EC-4C03-8C1C-6BD5F7C01D6F}" dt="2021-08-19T20:02:37.936" v="705" actId="478"/>
          <ac:cxnSpMkLst>
            <pc:docMk/>
            <pc:sldMk cId="4282255786" sldId="258"/>
            <ac:cxnSpMk id="7" creationId="{6B64027A-862A-4E22-90E2-85BD9E240BE9}"/>
          </ac:cxnSpMkLst>
        </pc:cxnChg>
        <pc:cxnChg chg="del">
          <ac:chgData name="Muhammad Usman Tariq" userId="03ce5289-4d1e-4316-81c6-77963b418d72" providerId="ADAL" clId="{1E2238AA-55EC-4C03-8C1C-6BD5F7C01D6F}" dt="2021-08-19T20:02:40.696" v="706" actId="478"/>
          <ac:cxnSpMkLst>
            <pc:docMk/>
            <pc:sldMk cId="4282255786" sldId="258"/>
            <ac:cxnSpMk id="9" creationId="{1DA50D1D-6D26-4DE8-B721-6431AB894EBA}"/>
          </ac:cxnSpMkLst>
        </pc:cxnChg>
        <pc:cxnChg chg="del">
          <ac:chgData name="Muhammad Usman Tariq" userId="03ce5289-4d1e-4316-81c6-77963b418d72" providerId="ADAL" clId="{1E2238AA-55EC-4C03-8C1C-6BD5F7C01D6F}" dt="2021-08-19T20:02:43.407" v="707" actId="478"/>
          <ac:cxnSpMkLst>
            <pc:docMk/>
            <pc:sldMk cId="4282255786" sldId="258"/>
            <ac:cxnSpMk id="11" creationId="{62901DC5-95F2-4C2D-ACBF-06E5B790E647}"/>
          </ac:cxnSpMkLst>
        </pc:cxnChg>
        <pc:cxnChg chg="mod">
          <ac:chgData name="Muhammad Usman Tariq" userId="03ce5289-4d1e-4316-81c6-77963b418d72" providerId="ADAL" clId="{1E2238AA-55EC-4C03-8C1C-6BD5F7C01D6F}" dt="2021-08-19T21:00:17.378" v="957" actId="14100"/>
          <ac:cxnSpMkLst>
            <pc:docMk/>
            <pc:sldMk cId="4282255786" sldId="258"/>
            <ac:cxnSpMk id="20" creationId="{01D50E07-3F5B-4380-B793-EDD337E0B1B4}"/>
          </ac:cxnSpMkLst>
        </pc:cxnChg>
        <pc:cxnChg chg="mod">
          <ac:chgData name="Muhammad Usman Tariq" userId="03ce5289-4d1e-4316-81c6-77963b418d72" providerId="ADAL" clId="{1E2238AA-55EC-4C03-8C1C-6BD5F7C01D6F}" dt="2021-08-19T21:00:13.129" v="956" actId="14100"/>
          <ac:cxnSpMkLst>
            <pc:docMk/>
            <pc:sldMk cId="4282255786" sldId="258"/>
            <ac:cxnSpMk id="22" creationId="{B4827745-2CFD-4CB4-9203-AD54138E6697}"/>
          </ac:cxnSpMkLst>
        </pc:cxnChg>
        <pc:cxnChg chg="mod">
          <ac:chgData name="Muhammad Usman Tariq" userId="03ce5289-4d1e-4316-81c6-77963b418d72" providerId="ADAL" clId="{1E2238AA-55EC-4C03-8C1C-6BD5F7C01D6F}" dt="2021-08-19T21:00:24.873" v="959" actId="14100"/>
          <ac:cxnSpMkLst>
            <pc:docMk/>
            <pc:sldMk cId="4282255786" sldId="258"/>
            <ac:cxnSpMk id="29" creationId="{4AFC2137-2E8B-4A11-82B8-D0E04820B80F}"/>
          </ac:cxnSpMkLst>
        </pc:cxnChg>
        <pc:cxnChg chg="mod">
          <ac:chgData name="Muhammad Usman Tariq" userId="03ce5289-4d1e-4316-81c6-77963b418d72" providerId="ADAL" clId="{1E2238AA-55EC-4C03-8C1C-6BD5F7C01D6F}" dt="2021-08-19T21:00:21.545" v="958" actId="14100"/>
          <ac:cxnSpMkLst>
            <pc:docMk/>
            <pc:sldMk cId="4282255786" sldId="258"/>
            <ac:cxnSpMk id="31" creationId="{C04DA262-DD1B-4CAA-8E23-1413DDA2E836}"/>
          </ac:cxnSpMkLst>
        </pc:cxnChg>
      </pc:sldChg>
      <pc:sldChg chg="addSp delSp modSp add mod">
        <pc:chgData name="Muhammad Usman Tariq" userId="03ce5289-4d1e-4316-81c6-77963b418d72" providerId="ADAL" clId="{1E2238AA-55EC-4C03-8C1C-6BD5F7C01D6F}" dt="2021-08-20T03:25:35.363" v="1300" actId="20577"/>
        <pc:sldMkLst>
          <pc:docMk/>
          <pc:sldMk cId="4045708485" sldId="259"/>
        </pc:sldMkLst>
        <pc:spChg chg="mod">
          <ac:chgData name="Muhammad Usman Tariq" userId="03ce5289-4d1e-4316-81c6-77963b418d72" providerId="ADAL" clId="{1E2238AA-55EC-4C03-8C1C-6BD5F7C01D6F}" dt="2021-08-20T03:23:04.969" v="1120" actId="20577"/>
          <ac:spMkLst>
            <pc:docMk/>
            <pc:sldMk cId="4045708485" sldId="259"/>
            <ac:spMk id="2" creationId="{EDD8D71D-F75E-4E1B-B133-00FD006678FA}"/>
          </ac:spMkLst>
        </pc:spChg>
        <pc:spChg chg="del">
          <ac:chgData name="Muhammad Usman Tariq" userId="03ce5289-4d1e-4316-81c6-77963b418d72" providerId="ADAL" clId="{1E2238AA-55EC-4C03-8C1C-6BD5F7C01D6F}" dt="2021-08-20T03:23:25.491" v="1128" actId="478"/>
          <ac:spMkLst>
            <pc:docMk/>
            <pc:sldMk cId="4045708485" sldId="259"/>
            <ac:spMk id="18" creationId="{1A63C70C-F645-4DAE-9D52-9E557BFE4695}"/>
          </ac:spMkLst>
        </pc:spChg>
        <pc:spChg chg="del">
          <ac:chgData name="Muhammad Usman Tariq" userId="03ce5289-4d1e-4316-81c6-77963b418d72" providerId="ADAL" clId="{1E2238AA-55EC-4C03-8C1C-6BD5F7C01D6F}" dt="2021-08-20T03:23:26.550" v="1129" actId="478"/>
          <ac:spMkLst>
            <pc:docMk/>
            <pc:sldMk cId="4045708485" sldId="259"/>
            <ac:spMk id="27" creationId="{9AAFCA83-2232-43EF-B256-EEE032F23D34}"/>
          </ac:spMkLst>
        </pc:spChg>
        <pc:spChg chg="mod">
          <ac:chgData name="Muhammad Usman Tariq" userId="03ce5289-4d1e-4316-81c6-77963b418d72" providerId="ADAL" clId="{1E2238AA-55EC-4C03-8C1C-6BD5F7C01D6F}" dt="2021-08-20T03:25:35.363" v="1300" actId="20577"/>
          <ac:spMkLst>
            <pc:docMk/>
            <pc:sldMk cId="4045708485" sldId="259"/>
            <ac:spMk id="35" creationId="{A5F8A1F2-A71D-4DAE-9145-AF4A0E42EC88}"/>
          </ac:spMkLst>
        </pc:spChg>
        <pc:spChg chg="del">
          <ac:chgData name="Muhammad Usman Tariq" userId="03ce5289-4d1e-4316-81c6-77963b418d72" providerId="ADAL" clId="{1E2238AA-55EC-4C03-8C1C-6BD5F7C01D6F}" dt="2021-08-20T03:23:20.913" v="1125" actId="478"/>
          <ac:spMkLst>
            <pc:docMk/>
            <pc:sldMk cId="4045708485" sldId="259"/>
            <ac:spMk id="36" creationId="{8211CE96-13CC-42DC-B3EB-F47F1B5F5003}"/>
          </ac:spMkLst>
        </pc:spChg>
        <pc:spChg chg="del">
          <ac:chgData name="Muhammad Usman Tariq" userId="03ce5289-4d1e-4316-81c6-77963b418d72" providerId="ADAL" clId="{1E2238AA-55EC-4C03-8C1C-6BD5F7C01D6F}" dt="2021-08-20T03:23:20.019" v="1124" actId="478"/>
          <ac:spMkLst>
            <pc:docMk/>
            <pc:sldMk cId="4045708485" sldId="259"/>
            <ac:spMk id="37" creationId="{83ACE920-DF24-48FC-8E68-B83E94C279EC}"/>
          </ac:spMkLst>
        </pc:spChg>
        <pc:grpChg chg="mod">
          <ac:chgData name="Muhammad Usman Tariq" userId="03ce5289-4d1e-4316-81c6-77963b418d72" providerId="ADAL" clId="{1E2238AA-55EC-4C03-8C1C-6BD5F7C01D6F}" dt="2021-08-20T03:23:53.070" v="1136" actId="1076"/>
          <ac:grpSpMkLst>
            <pc:docMk/>
            <pc:sldMk cId="4045708485" sldId="259"/>
            <ac:grpSpMk id="73" creationId="{B3393CF3-7729-429E-870E-C91642DF5E69}"/>
          </ac:grpSpMkLst>
        </pc:grpChg>
        <pc:picChg chg="del">
          <ac:chgData name="Muhammad Usman Tariq" userId="03ce5289-4d1e-4316-81c6-77963b418d72" providerId="ADAL" clId="{1E2238AA-55EC-4C03-8C1C-6BD5F7C01D6F}" dt="2021-08-20T03:23:16.811" v="1121" actId="478"/>
          <ac:picMkLst>
            <pc:docMk/>
            <pc:sldMk cId="4045708485" sldId="259"/>
            <ac:picMk id="4" creationId="{78C138B0-8358-4DD5-8724-D50110E5DA17}"/>
          </ac:picMkLst>
        </pc:picChg>
        <pc:picChg chg="add mod ord">
          <ac:chgData name="Muhammad Usman Tariq" userId="03ce5289-4d1e-4316-81c6-77963b418d72" providerId="ADAL" clId="{1E2238AA-55EC-4C03-8C1C-6BD5F7C01D6F}" dt="2021-08-20T03:23:49.672" v="1135" actId="1076"/>
          <ac:picMkLst>
            <pc:docMk/>
            <pc:sldMk cId="4045708485" sldId="259"/>
            <ac:picMk id="5" creationId="{C603D1AA-CD1C-4AE1-A9CF-145AB82EA5D7}"/>
          </ac:picMkLst>
        </pc:picChg>
        <pc:picChg chg="del">
          <ac:chgData name="Muhammad Usman Tariq" userId="03ce5289-4d1e-4316-81c6-77963b418d72" providerId="ADAL" clId="{1E2238AA-55EC-4C03-8C1C-6BD5F7C01D6F}" dt="2021-08-20T03:23:18.366" v="1122" actId="478"/>
          <ac:picMkLst>
            <pc:docMk/>
            <pc:sldMk cId="4045708485" sldId="259"/>
            <ac:picMk id="19" creationId="{D10D8797-26FF-42A3-B956-329D65B86EEF}"/>
          </ac:picMkLst>
        </pc:picChg>
        <pc:picChg chg="del">
          <ac:chgData name="Muhammad Usman Tariq" userId="03ce5289-4d1e-4316-81c6-77963b418d72" providerId="ADAL" clId="{1E2238AA-55EC-4C03-8C1C-6BD5F7C01D6F}" dt="2021-08-20T03:23:19.037" v="1123" actId="478"/>
          <ac:picMkLst>
            <pc:docMk/>
            <pc:sldMk cId="4045708485" sldId="259"/>
            <ac:picMk id="30" creationId="{8329928D-F36C-46C2-949F-50AC1AC47FC9}"/>
          </ac:picMkLst>
        </pc:picChg>
        <pc:cxnChg chg="del">
          <ac:chgData name="Muhammad Usman Tariq" userId="03ce5289-4d1e-4316-81c6-77963b418d72" providerId="ADAL" clId="{1E2238AA-55EC-4C03-8C1C-6BD5F7C01D6F}" dt="2021-08-20T03:23:25.491" v="1128" actId="478"/>
          <ac:cxnSpMkLst>
            <pc:docMk/>
            <pc:sldMk cId="4045708485" sldId="259"/>
            <ac:cxnSpMk id="20" creationId="{01D50E07-3F5B-4380-B793-EDD337E0B1B4}"/>
          </ac:cxnSpMkLst>
        </pc:cxnChg>
        <pc:cxnChg chg="del">
          <ac:chgData name="Muhammad Usman Tariq" userId="03ce5289-4d1e-4316-81c6-77963b418d72" providerId="ADAL" clId="{1E2238AA-55EC-4C03-8C1C-6BD5F7C01D6F}" dt="2021-08-20T03:23:25.491" v="1128" actId="478"/>
          <ac:cxnSpMkLst>
            <pc:docMk/>
            <pc:sldMk cId="4045708485" sldId="259"/>
            <ac:cxnSpMk id="22" creationId="{B4827745-2CFD-4CB4-9203-AD54138E6697}"/>
          </ac:cxnSpMkLst>
        </pc:cxnChg>
        <pc:cxnChg chg="del">
          <ac:chgData name="Muhammad Usman Tariq" userId="03ce5289-4d1e-4316-81c6-77963b418d72" providerId="ADAL" clId="{1E2238AA-55EC-4C03-8C1C-6BD5F7C01D6F}" dt="2021-08-20T03:23:22.051" v="1126" actId="478"/>
          <ac:cxnSpMkLst>
            <pc:docMk/>
            <pc:sldMk cId="4045708485" sldId="259"/>
            <ac:cxnSpMk id="29" creationId="{4AFC2137-2E8B-4A11-82B8-D0E04820B80F}"/>
          </ac:cxnSpMkLst>
        </pc:cxnChg>
        <pc:cxnChg chg="del">
          <ac:chgData name="Muhammad Usman Tariq" userId="03ce5289-4d1e-4316-81c6-77963b418d72" providerId="ADAL" clId="{1E2238AA-55EC-4C03-8C1C-6BD5F7C01D6F}" dt="2021-08-20T03:23:23.093" v="1127" actId="478"/>
          <ac:cxnSpMkLst>
            <pc:docMk/>
            <pc:sldMk cId="4045708485" sldId="259"/>
            <ac:cxnSpMk id="31" creationId="{C04DA262-DD1B-4CAA-8E23-1413DDA2E836}"/>
          </ac:cxnSpMkLst>
        </pc:cxnChg>
      </pc:sldChg>
    </pc:docChg>
  </pc:docChgLst>
  <pc:docChgLst>
    <pc:chgData name="Muhammad Usman Tariq" userId="03ce5289-4d1e-4316-81c6-77963b418d72" providerId="ADAL" clId="{2D9A8357-6057-4649-B0FF-0E81E0612E56}"/>
    <pc:docChg chg="custSel addSld modSld">
      <pc:chgData name="Muhammad Usman Tariq" userId="03ce5289-4d1e-4316-81c6-77963b418d72" providerId="ADAL" clId="{2D9A8357-6057-4649-B0FF-0E81E0612E56}" dt="2021-08-24T17:11:26.588" v="70" actId="20577"/>
      <pc:docMkLst>
        <pc:docMk/>
      </pc:docMkLst>
      <pc:sldChg chg="addSp delSp modSp add mod">
        <pc:chgData name="Muhammad Usman Tariq" userId="03ce5289-4d1e-4316-81c6-77963b418d72" providerId="ADAL" clId="{2D9A8357-6057-4649-B0FF-0E81E0612E56}" dt="2021-08-24T17:11:26.588" v="70" actId="20577"/>
        <pc:sldMkLst>
          <pc:docMk/>
          <pc:sldMk cId="1405023871" sldId="264"/>
        </pc:sldMkLst>
        <pc:spChg chg="mod">
          <ac:chgData name="Muhammad Usman Tariq" userId="03ce5289-4d1e-4316-81c6-77963b418d72" providerId="ADAL" clId="{2D9A8357-6057-4649-B0FF-0E81E0612E56}" dt="2021-08-24T17:11:26.588" v="70" actId="20577"/>
          <ac:spMkLst>
            <pc:docMk/>
            <pc:sldMk cId="1405023871" sldId="264"/>
            <ac:spMk id="2" creationId="{EDD8D71D-F75E-4E1B-B133-00FD006678FA}"/>
          </ac:spMkLst>
        </pc:spChg>
        <pc:grpChg chg="del">
          <ac:chgData name="Muhammad Usman Tariq" userId="03ce5289-4d1e-4316-81c6-77963b418d72" providerId="ADAL" clId="{2D9A8357-6057-4649-B0FF-0E81E0612E56}" dt="2021-08-24T17:10:42.165" v="59" actId="478"/>
          <ac:grpSpMkLst>
            <pc:docMk/>
            <pc:sldMk cId="1405023871" sldId="264"/>
            <ac:grpSpMk id="73" creationId="{B3393CF3-7729-429E-870E-C91642DF5E69}"/>
          </ac:grpSpMkLst>
        </pc:grpChg>
        <pc:picChg chg="del">
          <ac:chgData name="Muhammad Usman Tariq" userId="03ce5289-4d1e-4316-81c6-77963b418d72" providerId="ADAL" clId="{2D9A8357-6057-4649-B0FF-0E81E0612E56}" dt="2021-08-24T17:10:40.949" v="58" actId="478"/>
          <ac:picMkLst>
            <pc:docMk/>
            <pc:sldMk cId="1405023871" sldId="264"/>
            <ac:picMk id="4" creationId="{68310295-D42F-4590-9CB5-097DA6C22FB7}"/>
          </ac:picMkLst>
        </pc:picChg>
        <pc:picChg chg="add mod">
          <ac:chgData name="Muhammad Usman Tariq" userId="03ce5289-4d1e-4316-81c6-77963b418d72" providerId="ADAL" clId="{2D9A8357-6057-4649-B0FF-0E81E0612E56}" dt="2021-08-24T17:11:10.188" v="67" actId="14100"/>
          <ac:picMkLst>
            <pc:docMk/>
            <pc:sldMk cId="1405023871" sldId="264"/>
            <ac:picMk id="5" creationId="{42D620C7-5C35-4DE8-9C57-AD631E13BB75}"/>
          </ac:picMkLst>
        </pc:picChg>
      </pc:sldChg>
    </pc:docChg>
  </pc:docChgLst>
  <pc:docChgLst>
    <pc:chgData name="Muhammad Usman Tariq" userId="03ce5289-4d1e-4316-81c6-77963b418d72" providerId="ADAL" clId="{B50AFF08-4D28-42C6-8093-92A02254F1F9}"/>
    <pc:docChg chg="undo custSel addSld modSld">
      <pc:chgData name="Muhammad Usman Tariq" userId="03ce5289-4d1e-4316-81c6-77963b418d72" providerId="ADAL" clId="{B50AFF08-4D28-42C6-8093-92A02254F1F9}" dt="2021-08-18T16:48:07.624" v="428" actId="14100"/>
      <pc:docMkLst>
        <pc:docMk/>
      </pc:docMkLst>
      <pc:sldChg chg="addSp delSp modSp add mod">
        <pc:chgData name="Muhammad Usman Tariq" userId="03ce5289-4d1e-4316-81c6-77963b418d72" providerId="ADAL" clId="{B50AFF08-4D28-42C6-8093-92A02254F1F9}" dt="2021-08-18T16:48:07.624" v="428" actId="14100"/>
        <pc:sldMkLst>
          <pc:docMk/>
          <pc:sldMk cId="4282255786" sldId="258"/>
        </pc:sldMkLst>
        <pc:spChg chg="mod">
          <ac:chgData name="Muhammad Usman Tariq" userId="03ce5289-4d1e-4316-81c6-77963b418d72" providerId="ADAL" clId="{B50AFF08-4D28-42C6-8093-92A02254F1F9}" dt="2021-08-18T16:42:41.603" v="129" actId="20577"/>
          <ac:spMkLst>
            <pc:docMk/>
            <pc:sldMk cId="4282255786" sldId="258"/>
            <ac:spMk id="2" creationId="{EDD8D71D-F75E-4E1B-B133-00FD006678FA}"/>
          </ac:spMkLst>
        </pc:spChg>
        <pc:spChg chg="mod">
          <ac:chgData name="Muhammad Usman Tariq" userId="03ce5289-4d1e-4316-81c6-77963b418d72" providerId="ADAL" clId="{B50AFF08-4D28-42C6-8093-92A02254F1F9}" dt="2021-08-18T16:35:03.485" v="109" actId="1038"/>
          <ac:spMkLst>
            <pc:docMk/>
            <pc:sldMk cId="4282255786" sldId="258"/>
            <ac:spMk id="18" creationId="{1A63C70C-F645-4DAE-9D52-9E557BFE4695}"/>
          </ac:spMkLst>
        </pc:spChg>
        <pc:spChg chg="mod">
          <ac:chgData name="Muhammad Usman Tariq" userId="03ce5289-4d1e-4316-81c6-77963b418d72" providerId="ADAL" clId="{B50AFF08-4D28-42C6-8093-92A02254F1F9}" dt="2021-08-18T16:46:05.172" v="213" actId="1038"/>
          <ac:spMkLst>
            <pc:docMk/>
            <pc:sldMk cId="4282255786" sldId="258"/>
            <ac:spMk id="27" creationId="{9AAFCA83-2232-43EF-B256-EEE032F23D34}"/>
          </ac:spMkLst>
        </pc:spChg>
        <pc:spChg chg="mod">
          <ac:chgData name="Muhammad Usman Tariq" userId="03ce5289-4d1e-4316-81c6-77963b418d72" providerId="ADAL" clId="{B50AFF08-4D28-42C6-8093-92A02254F1F9}" dt="2021-08-18T16:47:53.814" v="426" actId="20577"/>
          <ac:spMkLst>
            <pc:docMk/>
            <pc:sldMk cId="4282255786" sldId="258"/>
            <ac:spMk id="35" creationId="{A5F8A1F2-A71D-4DAE-9145-AF4A0E42EC88}"/>
          </ac:spMkLst>
        </pc:spChg>
        <pc:picChg chg="del">
          <ac:chgData name="Muhammad Usman Tariq" userId="03ce5289-4d1e-4316-81c6-77963b418d72" providerId="ADAL" clId="{B50AFF08-4D28-42C6-8093-92A02254F1F9}" dt="2021-08-18T16:23:45.519" v="1" actId="478"/>
          <ac:picMkLst>
            <pc:docMk/>
            <pc:sldMk cId="4282255786" sldId="258"/>
            <ac:picMk id="4" creationId="{72480035-59F2-4973-9C0D-637BAAEE1133}"/>
          </ac:picMkLst>
        </pc:picChg>
        <pc:picChg chg="add mod ord">
          <ac:chgData name="Muhammad Usman Tariq" userId="03ce5289-4d1e-4316-81c6-77963b418d72" providerId="ADAL" clId="{B50AFF08-4D28-42C6-8093-92A02254F1F9}" dt="2021-08-18T16:34:50.879" v="40" actId="1076"/>
          <ac:picMkLst>
            <pc:docMk/>
            <pc:sldMk cId="4282255786" sldId="258"/>
            <ac:picMk id="6" creationId="{2C112391-0F8F-4F4E-8D4E-A804E537BE1D}"/>
          </ac:picMkLst>
        </pc:picChg>
        <pc:picChg chg="add mod ord">
          <ac:chgData name="Muhammad Usman Tariq" userId="03ce5289-4d1e-4316-81c6-77963b418d72" providerId="ADAL" clId="{B50AFF08-4D28-42C6-8093-92A02254F1F9}" dt="2021-08-18T16:34:39.244" v="38" actId="1038"/>
          <ac:picMkLst>
            <pc:docMk/>
            <pc:sldMk cId="4282255786" sldId="258"/>
            <ac:picMk id="10" creationId="{0E9FFE8E-0DD2-4A72-86DB-076C65F024AE}"/>
          </ac:picMkLst>
        </pc:picChg>
        <pc:picChg chg="add mod ord">
          <ac:chgData name="Muhammad Usman Tariq" userId="03ce5289-4d1e-4316-81c6-77963b418d72" providerId="ADAL" clId="{B50AFF08-4D28-42C6-8093-92A02254F1F9}" dt="2021-08-18T16:46:33.111" v="229" actId="1076"/>
          <ac:picMkLst>
            <pc:docMk/>
            <pc:sldMk cId="4282255786" sldId="258"/>
            <ac:picMk id="15" creationId="{660F9B6C-0812-424E-87E0-F5171DE391F1}"/>
          </ac:picMkLst>
        </pc:picChg>
        <pc:picChg chg="del">
          <ac:chgData name="Muhammad Usman Tariq" userId="03ce5289-4d1e-4316-81c6-77963b418d72" providerId="ADAL" clId="{B50AFF08-4D28-42C6-8093-92A02254F1F9}" dt="2021-08-18T16:34:27.284" v="34" actId="478"/>
          <ac:picMkLst>
            <pc:docMk/>
            <pc:sldMk cId="4282255786" sldId="258"/>
            <ac:picMk id="17" creationId="{CD1DBB49-60E5-4E61-B84A-A83F23B78902}"/>
          </ac:picMkLst>
        </pc:picChg>
        <pc:picChg chg="del">
          <ac:chgData name="Muhammad Usman Tariq" userId="03ce5289-4d1e-4316-81c6-77963b418d72" providerId="ADAL" clId="{B50AFF08-4D28-42C6-8093-92A02254F1F9}" dt="2021-08-18T16:31:58.218" v="16" actId="478"/>
          <ac:picMkLst>
            <pc:docMk/>
            <pc:sldMk cId="4282255786" sldId="258"/>
            <ac:picMk id="26" creationId="{4A74AF47-6B02-4770-B321-2A61BE4AB0D6}"/>
          </ac:picMkLst>
        </pc:picChg>
        <pc:cxnChg chg="mod">
          <ac:chgData name="Muhammad Usman Tariq" userId="03ce5289-4d1e-4316-81c6-77963b418d72" providerId="ADAL" clId="{B50AFF08-4D28-42C6-8093-92A02254F1F9}" dt="2021-08-18T16:35:11.935" v="110" actId="14100"/>
          <ac:cxnSpMkLst>
            <pc:docMk/>
            <pc:sldMk cId="4282255786" sldId="258"/>
            <ac:cxnSpMk id="20" creationId="{01D50E07-3F5B-4380-B793-EDD337E0B1B4}"/>
          </ac:cxnSpMkLst>
        </pc:cxnChg>
        <pc:cxnChg chg="mod">
          <ac:chgData name="Muhammad Usman Tariq" userId="03ce5289-4d1e-4316-81c6-77963b418d72" providerId="ADAL" clId="{B50AFF08-4D28-42C6-8093-92A02254F1F9}" dt="2021-08-18T16:35:17.278" v="111" actId="14100"/>
          <ac:cxnSpMkLst>
            <pc:docMk/>
            <pc:sldMk cId="4282255786" sldId="258"/>
            <ac:cxnSpMk id="22" creationId="{B4827745-2CFD-4CB4-9203-AD54138E6697}"/>
          </ac:cxnSpMkLst>
        </pc:cxnChg>
        <pc:cxnChg chg="mod">
          <ac:chgData name="Muhammad Usman Tariq" userId="03ce5289-4d1e-4316-81c6-77963b418d72" providerId="ADAL" clId="{B50AFF08-4D28-42C6-8093-92A02254F1F9}" dt="2021-08-18T16:48:03.248" v="427" actId="14100"/>
          <ac:cxnSpMkLst>
            <pc:docMk/>
            <pc:sldMk cId="4282255786" sldId="258"/>
            <ac:cxnSpMk id="29" creationId="{4AFC2137-2E8B-4A11-82B8-D0E04820B80F}"/>
          </ac:cxnSpMkLst>
        </pc:cxnChg>
        <pc:cxnChg chg="mod">
          <ac:chgData name="Muhammad Usman Tariq" userId="03ce5289-4d1e-4316-81c6-77963b418d72" providerId="ADAL" clId="{B50AFF08-4D28-42C6-8093-92A02254F1F9}" dt="2021-08-18T16:48:07.624" v="428" actId="14100"/>
          <ac:cxnSpMkLst>
            <pc:docMk/>
            <pc:sldMk cId="4282255786" sldId="258"/>
            <ac:cxnSpMk id="31" creationId="{C04DA262-DD1B-4CAA-8E23-1413DDA2E836}"/>
          </ac:cxnSpMkLst>
        </pc:cxnChg>
      </pc:sldChg>
    </pc:docChg>
  </pc:docChgLst>
  <pc:docChgLst>
    <pc:chgData name="Muhammad Usman Tariq" userId="03ce5289-4d1e-4316-81c6-77963b418d72" providerId="ADAL" clId="{C597C1DF-3061-4C03-8786-F4A9FAE19B1F}"/>
    <pc:docChg chg="delSld modSld">
      <pc:chgData name="Muhammad Usman Tariq" userId="03ce5289-4d1e-4316-81c6-77963b418d72" providerId="ADAL" clId="{C597C1DF-3061-4C03-8786-F4A9FAE19B1F}" dt="2021-09-02T23:39:58.344" v="10" actId="20577"/>
      <pc:docMkLst>
        <pc:docMk/>
      </pc:docMkLst>
      <pc:sldChg chg="modSp mod">
        <pc:chgData name="Muhammad Usman Tariq" userId="03ce5289-4d1e-4316-81c6-77963b418d72" providerId="ADAL" clId="{C597C1DF-3061-4C03-8786-F4A9FAE19B1F}" dt="2021-09-02T23:39:58.344" v="10" actId="20577"/>
        <pc:sldMkLst>
          <pc:docMk/>
          <pc:sldMk cId="2700437164" sldId="256"/>
        </pc:sldMkLst>
        <pc:spChg chg="mod">
          <ac:chgData name="Muhammad Usman Tariq" userId="03ce5289-4d1e-4316-81c6-77963b418d72" providerId="ADAL" clId="{C597C1DF-3061-4C03-8786-F4A9FAE19B1F}" dt="2021-09-02T23:39:58.344" v="10" actId="20577"/>
          <ac:spMkLst>
            <pc:docMk/>
            <pc:sldMk cId="2700437164" sldId="256"/>
            <ac:spMk id="3" creationId="{F705DE93-DCCD-4564-BAA3-655C9D83320C}"/>
          </ac:spMkLst>
        </pc:spChg>
      </pc:sldChg>
      <pc:sldChg chg="del">
        <pc:chgData name="Muhammad Usman Tariq" userId="03ce5289-4d1e-4316-81c6-77963b418d72" providerId="ADAL" clId="{C597C1DF-3061-4C03-8786-F4A9FAE19B1F}" dt="2021-09-02T23:39:26.642" v="0" actId="47"/>
        <pc:sldMkLst>
          <pc:docMk/>
          <pc:sldMk cId="495918903" sldId="261"/>
        </pc:sldMkLst>
      </pc:sldChg>
      <pc:sldChg chg="del">
        <pc:chgData name="Muhammad Usman Tariq" userId="03ce5289-4d1e-4316-81c6-77963b418d72" providerId="ADAL" clId="{C597C1DF-3061-4C03-8786-F4A9FAE19B1F}" dt="2021-09-02T23:39:35.896" v="2" actId="47"/>
        <pc:sldMkLst>
          <pc:docMk/>
          <pc:sldMk cId="1405023871" sldId="264"/>
        </pc:sldMkLst>
      </pc:sldChg>
      <pc:sldChg chg="del">
        <pc:chgData name="Muhammad Usman Tariq" userId="03ce5289-4d1e-4316-81c6-77963b418d72" providerId="ADAL" clId="{C597C1DF-3061-4C03-8786-F4A9FAE19B1F}" dt="2021-09-02T23:39:34.943" v="1" actId="47"/>
        <pc:sldMkLst>
          <pc:docMk/>
          <pc:sldMk cId="922791799" sldId="265"/>
        </pc:sldMkLst>
      </pc:sldChg>
      <pc:sldChg chg="del">
        <pc:chgData name="Muhammad Usman Tariq" userId="03ce5289-4d1e-4316-81c6-77963b418d72" providerId="ADAL" clId="{C597C1DF-3061-4C03-8786-F4A9FAE19B1F}" dt="2021-09-02T23:39:36.852" v="3" actId="47"/>
        <pc:sldMkLst>
          <pc:docMk/>
          <pc:sldMk cId="2505558454" sldId="266"/>
        </pc:sldMkLst>
      </pc:sldChg>
      <pc:sldChg chg="del">
        <pc:chgData name="Muhammad Usman Tariq" userId="03ce5289-4d1e-4316-81c6-77963b418d72" providerId="ADAL" clId="{C597C1DF-3061-4C03-8786-F4A9FAE19B1F}" dt="2021-09-02T23:39:39.085" v="4" actId="47"/>
        <pc:sldMkLst>
          <pc:docMk/>
          <pc:sldMk cId="3446080782" sldId="26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24204C7-EEF8-4456-BFCA-5A4628B3C26A}" type="datetimeFigureOut">
              <a:rPr lang="en-US" smtClean="0"/>
              <a:t>9/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51B859D-AA04-4847-8130-6642CE01AA15}" type="slidenum">
              <a:rPr lang="en-US" smtClean="0"/>
              <a:t>‹#›</a:t>
            </a:fld>
            <a:endParaRPr lang="en-US"/>
          </a:p>
        </p:txBody>
      </p:sp>
    </p:spTree>
    <p:extLst>
      <p:ext uri="{BB962C8B-B14F-4D97-AF65-F5344CB8AC3E}">
        <p14:creationId xmlns:p14="http://schemas.microsoft.com/office/powerpoint/2010/main" val="27108209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1B859D-AA04-4847-8130-6642CE01AA15}" type="slidenum">
              <a:rPr lang="en-US" smtClean="0"/>
              <a:t>2</a:t>
            </a:fld>
            <a:endParaRPr lang="en-US"/>
          </a:p>
        </p:txBody>
      </p:sp>
    </p:spTree>
    <p:extLst>
      <p:ext uri="{BB962C8B-B14F-4D97-AF65-F5344CB8AC3E}">
        <p14:creationId xmlns:p14="http://schemas.microsoft.com/office/powerpoint/2010/main" val="2912580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1B859D-AA04-4847-8130-6642CE01AA15}" type="slidenum">
              <a:rPr lang="en-US" smtClean="0"/>
              <a:t>4</a:t>
            </a:fld>
            <a:endParaRPr lang="en-US"/>
          </a:p>
        </p:txBody>
      </p:sp>
    </p:spTree>
    <p:extLst>
      <p:ext uri="{BB962C8B-B14F-4D97-AF65-F5344CB8AC3E}">
        <p14:creationId xmlns:p14="http://schemas.microsoft.com/office/powerpoint/2010/main" val="14207535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1B859D-AA04-4847-8130-6642CE01AA15}" type="slidenum">
              <a:rPr lang="en-US" smtClean="0"/>
              <a:t>5</a:t>
            </a:fld>
            <a:endParaRPr lang="en-US"/>
          </a:p>
        </p:txBody>
      </p:sp>
    </p:spTree>
    <p:extLst>
      <p:ext uri="{BB962C8B-B14F-4D97-AF65-F5344CB8AC3E}">
        <p14:creationId xmlns:p14="http://schemas.microsoft.com/office/powerpoint/2010/main" val="38534356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1B859D-AA04-4847-8130-6642CE01AA15}" type="slidenum">
              <a:rPr lang="en-US" smtClean="0"/>
              <a:t>6</a:t>
            </a:fld>
            <a:endParaRPr lang="en-US"/>
          </a:p>
        </p:txBody>
      </p:sp>
    </p:spTree>
    <p:extLst>
      <p:ext uri="{BB962C8B-B14F-4D97-AF65-F5344CB8AC3E}">
        <p14:creationId xmlns:p14="http://schemas.microsoft.com/office/powerpoint/2010/main" val="8920802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1B859D-AA04-4847-8130-6642CE01AA15}" type="slidenum">
              <a:rPr lang="en-US" smtClean="0"/>
              <a:t>7</a:t>
            </a:fld>
            <a:endParaRPr lang="en-US"/>
          </a:p>
        </p:txBody>
      </p:sp>
    </p:spTree>
    <p:extLst>
      <p:ext uri="{BB962C8B-B14F-4D97-AF65-F5344CB8AC3E}">
        <p14:creationId xmlns:p14="http://schemas.microsoft.com/office/powerpoint/2010/main" val="42204881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D1074D-FC48-4FC4-B36B-B73BDA88554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6376562-9083-4DA2-9268-10E2EFD58A8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D8FEBB1-C94F-4BFD-9961-EDEBD4805FF3}"/>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129E5A07-7A69-47F7-976E-41E70B44372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89DD1BA-E302-46CA-BDD5-D24B3CD0C48F}"/>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21366078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FB93E3-D0E8-42DC-9FBD-C3D7E55E5D7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00A8676-38F0-4321-BB0C-4053EB2E1F1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F8AC47-E0E2-4D6A-ABF0-FA53BCD18876}"/>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D125F552-3778-412A-86C2-BDE4154692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C2EDD0B-FDCE-446B-8909-241752DEB19E}"/>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2127702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918E708-6163-4B53-BDAF-35EBEC3F261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F20B546-4E4D-49D0-8433-E11DFE8595D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58B4C0-F614-47E5-BA64-AB7A23553331}"/>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CFB200B9-8398-4B83-AC4D-6F6F79811D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256B53-DD5C-4568-9600-CA76FA81F58A}"/>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12845334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C48058-D5C5-4870-B113-B0480186CBC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86A8B22-5631-4A51-BC81-6CA7B7B46D1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EBBEE9-BBF9-46BB-8DE4-E13766BEEAEE}"/>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726D1E06-0C2E-4FD5-80C5-9F75B4B03F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61F6E3-42FE-4DE3-9CC5-3528D1F69C40}"/>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3487121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41059-1F2F-4FEF-9FBD-F8D028B4757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F5CCAA2-96D5-4B82-9A70-D5BC1BA4167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AABE3F4-0AB3-45E3-AA16-6E44575EA444}"/>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1BE6A065-1D01-4944-ADD8-169A4293B6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F31716-2BC6-4D65-A726-31617D78C9EF}"/>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37089494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01306C-3C8C-4EF0-A98B-2BBC4A9EDC1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D93197A-FFF5-4536-8B3D-87F75B561DD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F6F38CF-60DD-4782-BBB8-D8F974F3F78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1FE01E3-8CDC-45A9-96F7-C25D6AE61293}"/>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6" name="Footer Placeholder 5">
            <a:extLst>
              <a:ext uri="{FF2B5EF4-FFF2-40B4-BE49-F238E27FC236}">
                <a16:creationId xmlns:a16="http://schemas.microsoft.com/office/drawing/2014/main" id="{669D6DA0-7942-4C91-8738-45CDC402B6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C387A0-A17C-49E6-8E42-D152BBF2371C}"/>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5991775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8E87B2-20C6-4E6B-A202-25B545340A4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434F836-CE10-4D2C-91F3-55812C89D34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485B5AF-27CB-4CA4-AD5C-D8BE022D0F5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B1582F8-5DCC-48E1-BE65-322237455C8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B89A2B7-69BD-44E0-8EC3-E9DB782C394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13B9423-F5F1-48AE-9044-3DBF80F39F5F}"/>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8" name="Footer Placeholder 7">
            <a:extLst>
              <a:ext uri="{FF2B5EF4-FFF2-40B4-BE49-F238E27FC236}">
                <a16:creationId xmlns:a16="http://schemas.microsoft.com/office/drawing/2014/main" id="{B53A0D53-62D3-436A-ACE0-A9E10E16E03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42F8BFD-3D70-416C-B1D6-A2AE62D2FE8F}"/>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626467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9074C7-30DB-4351-85F5-3BE1C42343C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707FA07-69CC-4CEB-B3BC-B2EA19571FB4}"/>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4" name="Footer Placeholder 3">
            <a:extLst>
              <a:ext uri="{FF2B5EF4-FFF2-40B4-BE49-F238E27FC236}">
                <a16:creationId xmlns:a16="http://schemas.microsoft.com/office/drawing/2014/main" id="{9A8F7309-E508-4E22-B5B1-D6A7638D16F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9A8DA5E-16F0-4960-9084-3C6FE5791E79}"/>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15564818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7AD1A51-B6CA-480D-B8DD-46877341A770}"/>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3" name="Footer Placeholder 2">
            <a:extLst>
              <a:ext uri="{FF2B5EF4-FFF2-40B4-BE49-F238E27FC236}">
                <a16:creationId xmlns:a16="http://schemas.microsoft.com/office/drawing/2014/main" id="{F9842C9D-2DF0-4B25-9662-18CD39E1B1F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A67BBC8-C6DD-4F69-8208-7C0DA72EBC7F}"/>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36058354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912C9C-F388-49EA-9F1E-C63C549F7B2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A4C23D4-CB70-4C1B-9354-4F8D4419BFA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FB53145-EEFB-47DA-8805-3B7CF73E76C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2BEB721-9C3F-426C-A31C-6D2480BF1D1B}"/>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6" name="Footer Placeholder 5">
            <a:extLst>
              <a:ext uri="{FF2B5EF4-FFF2-40B4-BE49-F238E27FC236}">
                <a16:creationId xmlns:a16="http://schemas.microsoft.com/office/drawing/2014/main" id="{A0A86F3B-0388-4FFC-9E00-572FD843857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6C3ADE-9DE4-47AB-BF3F-C032B51753D4}"/>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1356955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5AB540-083F-40D7-BA68-1D2BBB84650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EDCE347-882C-4FC3-B4C7-FE916A7909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28734E5-EB35-4D41-AD12-0EDC3C88F1B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1D0842-9169-4B11-80D1-1910F7047BC0}"/>
              </a:ext>
            </a:extLst>
          </p:cNvPr>
          <p:cNvSpPr>
            <a:spLocks noGrp="1"/>
          </p:cNvSpPr>
          <p:nvPr>
            <p:ph type="dt" sz="half" idx="10"/>
          </p:nvPr>
        </p:nvSpPr>
        <p:spPr/>
        <p:txBody>
          <a:bodyPr/>
          <a:lstStyle/>
          <a:p>
            <a:fld id="{776A0B15-42D2-4D35-9A11-81BC81C10A61}" type="datetimeFigureOut">
              <a:rPr lang="en-US" smtClean="0"/>
              <a:t>9/2/2021</a:t>
            </a:fld>
            <a:endParaRPr lang="en-US"/>
          </a:p>
        </p:txBody>
      </p:sp>
      <p:sp>
        <p:nvSpPr>
          <p:cNvPr id="6" name="Footer Placeholder 5">
            <a:extLst>
              <a:ext uri="{FF2B5EF4-FFF2-40B4-BE49-F238E27FC236}">
                <a16:creationId xmlns:a16="http://schemas.microsoft.com/office/drawing/2014/main" id="{194953C4-A13A-4EC6-8D13-A50306E2A10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426C64-E081-4612-A70F-199D87FC858A}"/>
              </a:ext>
            </a:extLst>
          </p:cNvPr>
          <p:cNvSpPr>
            <a:spLocks noGrp="1"/>
          </p:cNvSpPr>
          <p:nvPr>
            <p:ph type="sldNum" sz="quarter" idx="12"/>
          </p:nvPr>
        </p:nvSpPr>
        <p:spPr/>
        <p:txBody>
          <a:bodyPr/>
          <a:lstStyle/>
          <a:p>
            <a:fld id="{E9746CB3-4F96-48C3-96D8-5053FD132668}" type="slidenum">
              <a:rPr lang="en-US" smtClean="0"/>
              <a:t>‹#›</a:t>
            </a:fld>
            <a:endParaRPr lang="en-US"/>
          </a:p>
        </p:txBody>
      </p:sp>
    </p:spTree>
    <p:extLst>
      <p:ext uri="{BB962C8B-B14F-4D97-AF65-F5344CB8AC3E}">
        <p14:creationId xmlns:p14="http://schemas.microsoft.com/office/powerpoint/2010/main" val="31318051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772DD07-11C1-47F5-B73D-663CCA03DBD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4F6888-EA36-445B-9A57-5E86FB63B32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EC6C53-F45F-4503-BF1B-7A52339A0E4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76A0B15-42D2-4D35-9A11-81BC81C10A61}" type="datetimeFigureOut">
              <a:rPr lang="en-US" smtClean="0"/>
              <a:t>9/2/2021</a:t>
            </a:fld>
            <a:endParaRPr lang="en-US"/>
          </a:p>
        </p:txBody>
      </p:sp>
      <p:sp>
        <p:nvSpPr>
          <p:cNvPr id="5" name="Footer Placeholder 4">
            <a:extLst>
              <a:ext uri="{FF2B5EF4-FFF2-40B4-BE49-F238E27FC236}">
                <a16:creationId xmlns:a16="http://schemas.microsoft.com/office/drawing/2014/main" id="{E456DF1F-F319-4CD5-A9B2-F02CC2F4398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5B80CD7-94DE-474E-9D16-83DF4216774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9746CB3-4F96-48C3-96D8-5053FD132668}" type="slidenum">
              <a:rPr lang="en-US" smtClean="0"/>
              <a:t>‹#›</a:t>
            </a:fld>
            <a:endParaRPr lang="en-US"/>
          </a:p>
        </p:txBody>
      </p:sp>
    </p:spTree>
    <p:extLst>
      <p:ext uri="{BB962C8B-B14F-4D97-AF65-F5344CB8AC3E}">
        <p14:creationId xmlns:p14="http://schemas.microsoft.com/office/powerpoint/2010/main" val="2309149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6.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D97D53-33ED-432C-A815-6D718233796C}"/>
              </a:ext>
            </a:extLst>
          </p:cNvPr>
          <p:cNvSpPr>
            <a:spLocks noGrp="1"/>
          </p:cNvSpPr>
          <p:nvPr>
            <p:ph type="ctrTitle"/>
          </p:nvPr>
        </p:nvSpPr>
        <p:spPr/>
        <p:txBody>
          <a:bodyPr/>
          <a:lstStyle/>
          <a:p>
            <a:r>
              <a:rPr lang="en-US" dirty="0"/>
              <a:t>UMAP Projections</a:t>
            </a:r>
          </a:p>
        </p:txBody>
      </p:sp>
      <p:sp>
        <p:nvSpPr>
          <p:cNvPr id="3" name="Subtitle 2">
            <a:extLst>
              <a:ext uri="{FF2B5EF4-FFF2-40B4-BE49-F238E27FC236}">
                <a16:creationId xmlns:a16="http://schemas.microsoft.com/office/drawing/2014/main" id="{F705DE93-DCCD-4564-BAA3-655C9D83320C}"/>
              </a:ext>
            </a:extLst>
          </p:cNvPr>
          <p:cNvSpPr>
            <a:spLocks noGrp="1"/>
          </p:cNvSpPr>
          <p:nvPr>
            <p:ph type="subTitle" idx="1"/>
          </p:nvPr>
        </p:nvSpPr>
        <p:spPr/>
        <p:txBody>
          <a:bodyPr/>
          <a:lstStyle/>
          <a:p>
            <a:r>
              <a:rPr lang="en-US" dirty="0"/>
              <a:t>Usman Tariq</a:t>
            </a:r>
          </a:p>
          <a:p>
            <a:r>
              <a:rPr lang="en-US"/>
              <a:t>09/02/2021</a:t>
            </a:r>
            <a:endParaRPr lang="en-US" dirty="0"/>
          </a:p>
        </p:txBody>
      </p:sp>
    </p:spTree>
    <p:extLst>
      <p:ext uri="{BB962C8B-B14F-4D97-AF65-F5344CB8AC3E}">
        <p14:creationId xmlns:p14="http://schemas.microsoft.com/office/powerpoint/2010/main" val="27004371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5"/>
            <a:ext cx="10515600" cy="1272819"/>
          </a:xfrm>
        </p:spPr>
        <p:txBody>
          <a:bodyPr>
            <a:normAutofit/>
          </a:bodyPr>
          <a:lstStyle/>
          <a:p>
            <a:r>
              <a:rPr lang="en-US" sz="2800" dirty="0"/>
              <a:t>Human HCD </a:t>
            </a:r>
            <a:r>
              <a:rPr lang="en-US" sz="2800" dirty="0" err="1"/>
              <a:t>Phospho</a:t>
            </a:r>
            <a:r>
              <a:rPr lang="en-US" sz="2800" dirty="0"/>
              <a:t> Dataset (Precursor Mass 2000Da +- 1Da)</a:t>
            </a:r>
          </a:p>
        </p:txBody>
      </p:sp>
      <p:pic>
        <p:nvPicPr>
          <p:cNvPr id="4" name="Picture 3" descr="Chart, scatter chart&#10;&#10;Description automatically generated">
            <a:extLst>
              <a:ext uri="{FF2B5EF4-FFF2-40B4-BE49-F238E27FC236}">
                <a16:creationId xmlns:a16="http://schemas.microsoft.com/office/drawing/2014/main" id="{78C138B0-8358-4DD5-8724-D50110E5DA1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72106" y="2272560"/>
            <a:ext cx="5719894" cy="4575915"/>
          </a:xfrm>
          <a:prstGeom prst="rect">
            <a:avLst/>
          </a:prstGeom>
        </p:spPr>
      </p:pic>
      <p:pic>
        <p:nvPicPr>
          <p:cNvPr id="30" name="Picture 29" descr="Chart, scatter chart&#10;&#10;Description automatically generated">
            <a:extLst>
              <a:ext uri="{FF2B5EF4-FFF2-40B4-BE49-F238E27FC236}">
                <a16:creationId xmlns:a16="http://schemas.microsoft.com/office/drawing/2014/main" id="{8329928D-F36C-46C2-949F-50AC1AC47FC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18744" y="4437909"/>
            <a:ext cx="2358955" cy="1769216"/>
          </a:xfrm>
          <a:prstGeom prst="rect">
            <a:avLst/>
          </a:prstGeom>
        </p:spPr>
      </p:pic>
      <p:pic>
        <p:nvPicPr>
          <p:cNvPr id="19" name="Picture 18" descr="Chart, scatter chart&#10;&#10;Description automatically generated">
            <a:extLst>
              <a:ext uri="{FF2B5EF4-FFF2-40B4-BE49-F238E27FC236}">
                <a16:creationId xmlns:a16="http://schemas.microsoft.com/office/drawing/2014/main" id="{D10D8797-26FF-42A3-B956-329D65B86EE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318743" y="2722288"/>
            <a:ext cx="2358955" cy="1769216"/>
          </a:xfrm>
          <a:prstGeom prst="rect">
            <a:avLst/>
          </a:prstGeom>
        </p:spPr>
      </p:pic>
      <p:sp>
        <p:nvSpPr>
          <p:cNvPr id="18" name="Rectangle 17">
            <a:extLst>
              <a:ext uri="{FF2B5EF4-FFF2-40B4-BE49-F238E27FC236}">
                <a16:creationId xmlns:a16="http://schemas.microsoft.com/office/drawing/2014/main" id="{1A63C70C-F645-4DAE-9D52-9E557BFE4695}"/>
              </a:ext>
            </a:extLst>
          </p:cNvPr>
          <p:cNvSpPr/>
          <p:nvPr/>
        </p:nvSpPr>
        <p:spPr>
          <a:xfrm>
            <a:off x="8862271" y="5683979"/>
            <a:ext cx="147506" cy="19250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01D50E07-3F5B-4380-B793-EDD337E0B1B4}"/>
              </a:ext>
            </a:extLst>
          </p:cNvPr>
          <p:cNvCxnSpPr>
            <a:cxnSpLocks/>
          </p:cNvCxnSpPr>
          <p:nvPr/>
        </p:nvCxnSpPr>
        <p:spPr>
          <a:xfrm flipH="1" flipV="1">
            <a:off x="6195269" y="4815281"/>
            <a:ext cx="2667002" cy="868699"/>
          </a:xfrm>
          <a:prstGeom prst="line">
            <a:avLst/>
          </a:prstGeom>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B4827745-2CFD-4CB4-9203-AD54138E6697}"/>
              </a:ext>
            </a:extLst>
          </p:cNvPr>
          <p:cNvCxnSpPr>
            <a:cxnSpLocks/>
          </p:cNvCxnSpPr>
          <p:nvPr/>
        </p:nvCxnSpPr>
        <p:spPr>
          <a:xfrm flipH="1" flipV="1">
            <a:off x="6195269" y="5733875"/>
            <a:ext cx="2667002" cy="142613"/>
          </a:xfrm>
          <a:prstGeom prst="line">
            <a:avLst/>
          </a:prstGeom>
        </p:spPr>
        <p:style>
          <a:lnRef idx="1">
            <a:schemeClr val="dk1"/>
          </a:lnRef>
          <a:fillRef idx="0">
            <a:schemeClr val="dk1"/>
          </a:fillRef>
          <a:effectRef idx="0">
            <a:schemeClr val="dk1"/>
          </a:effectRef>
          <a:fontRef idx="minor">
            <a:schemeClr val="tx1"/>
          </a:fontRef>
        </p:style>
      </p:cxnSp>
      <p:sp>
        <p:nvSpPr>
          <p:cNvPr id="27" name="Rectangle 26">
            <a:extLst>
              <a:ext uri="{FF2B5EF4-FFF2-40B4-BE49-F238E27FC236}">
                <a16:creationId xmlns:a16="http://schemas.microsoft.com/office/drawing/2014/main" id="{9AAFCA83-2232-43EF-B256-EEE032F23D34}"/>
              </a:ext>
            </a:extLst>
          </p:cNvPr>
          <p:cNvSpPr/>
          <p:nvPr/>
        </p:nvSpPr>
        <p:spPr>
          <a:xfrm>
            <a:off x="9542740" y="3458361"/>
            <a:ext cx="389826" cy="22895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9" name="Straight Connector 28">
            <a:extLst>
              <a:ext uri="{FF2B5EF4-FFF2-40B4-BE49-F238E27FC236}">
                <a16:creationId xmlns:a16="http://schemas.microsoft.com/office/drawing/2014/main" id="{4AFC2137-2E8B-4A11-82B8-D0E04820B80F}"/>
              </a:ext>
            </a:extLst>
          </p:cNvPr>
          <p:cNvCxnSpPr>
            <a:cxnSpLocks/>
          </p:cNvCxnSpPr>
          <p:nvPr/>
        </p:nvCxnSpPr>
        <p:spPr>
          <a:xfrm flipH="1" flipV="1">
            <a:off x="6195269" y="3076933"/>
            <a:ext cx="3347472" cy="381431"/>
          </a:xfrm>
          <a:prstGeom prst="line">
            <a:avLst/>
          </a:prstGeom>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C04DA262-DD1B-4CAA-8E23-1413DDA2E836}"/>
              </a:ext>
            </a:extLst>
          </p:cNvPr>
          <p:cNvCxnSpPr>
            <a:cxnSpLocks/>
          </p:cNvCxnSpPr>
          <p:nvPr/>
        </p:nvCxnSpPr>
        <p:spPr>
          <a:xfrm flipH="1">
            <a:off x="6195269" y="3687312"/>
            <a:ext cx="3347470" cy="318657"/>
          </a:xfrm>
          <a:prstGeom prst="line">
            <a:avLst/>
          </a:prstGeom>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A5F8A1F2-A71D-4DAE-9145-AF4A0E42EC88}"/>
              </a:ext>
            </a:extLst>
          </p:cNvPr>
          <p:cNvSpPr txBox="1"/>
          <p:nvPr/>
        </p:nvSpPr>
        <p:spPr>
          <a:xfrm>
            <a:off x="838200" y="1715914"/>
            <a:ext cx="3220985" cy="2462213"/>
          </a:xfrm>
          <a:prstGeom prst="rect">
            <a:avLst/>
          </a:prstGeom>
          <a:noFill/>
        </p:spPr>
        <p:txBody>
          <a:bodyPr wrap="square" rtlCol="0">
            <a:spAutoFit/>
          </a:bodyPr>
          <a:lstStyle/>
          <a:p>
            <a:r>
              <a:rPr lang="en-US" sz="1400" dirty="0"/>
              <a:t>Each cluster in the figure represents a peptide and its corresponding spectra. As can be seen, for most peptides, spectra with different charges are projected close to the peptide. However, there are cases where the spectra with charge 3,4 are farther than those with charge 2 (</a:t>
            </a:r>
            <a:r>
              <a:rPr lang="en-US" sz="1400" dirty="0" err="1"/>
              <a:t>subfig</a:t>
            </a:r>
            <a:r>
              <a:rPr lang="en-US" sz="1400" dirty="0"/>
              <a:t> b). while in other cases the network learns embeddings for higher charge better than those for precursor charge 2 spectra (</a:t>
            </a:r>
            <a:r>
              <a:rPr lang="en-US" sz="1400" dirty="0" err="1"/>
              <a:t>subfig</a:t>
            </a:r>
            <a:r>
              <a:rPr lang="en-US" sz="1400" dirty="0"/>
              <a:t> a)</a:t>
            </a:r>
          </a:p>
        </p:txBody>
      </p:sp>
      <p:sp>
        <p:nvSpPr>
          <p:cNvPr id="36" name="TextBox 35">
            <a:extLst>
              <a:ext uri="{FF2B5EF4-FFF2-40B4-BE49-F238E27FC236}">
                <a16:creationId xmlns:a16="http://schemas.microsoft.com/office/drawing/2014/main" id="{8211CE96-13CC-42DC-B3EB-F47F1B5F5003}"/>
              </a:ext>
            </a:extLst>
          </p:cNvPr>
          <p:cNvSpPr txBox="1"/>
          <p:nvPr/>
        </p:nvSpPr>
        <p:spPr>
          <a:xfrm>
            <a:off x="4070508" y="3059668"/>
            <a:ext cx="365806" cy="369332"/>
          </a:xfrm>
          <a:prstGeom prst="rect">
            <a:avLst/>
          </a:prstGeom>
          <a:noFill/>
        </p:spPr>
        <p:txBody>
          <a:bodyPr wrap="none" rtlCol="0">
            <a:spAutoFit/>
          </a:bodyPr>
          <a:lstStyle/>
          <a:p>
            <a:r>
              <a:rPr lang="en-US" dirty="0"/>
              <a:t>a)</a:t>
            </a:r>
          </a:p>
        </p:txBody>
      </p:sp>
      <p:sp>
        <p:nvSpPr>
          <p:cNvPr id="37" name="TextBox 36">
            <a:extLst>
              <a:ext uri="{FF2B5EF4-FFF2-40B4-BE49-F238E27FC236}">
                <a16:creationId xmlns:a16="http://schemas.microsoft.com/office/drawing/2014/main" id="{83ACE920-DF24-48FC-8E68-B83E94C279EC}"/>
              </a:ext>
            </a:extLst>
          </p:cNvPr>
          <p:cNvSpPr txBox="1"/>
          <p:nvPr/>
        </p:nvSpPr>
        <p:spPr>
          <a:xfrm>
            <a:off x="4059288" y="4778126"/>
            <a:ext cx="377026" cy="369332"/>
          </a:xfrm>
          <a:prstGeom prst="rect">
            <a:avLst/>
          </a:prstGeom>
          <a:noFill/>
        </p:spPr>
        <p:txBody>
          <a:bodyPr wrap="none" rtlCol="0">
            <a:spAutoFit/>
          </a:bodyPr>
          <a:lstStyle/>
          <a:p>
            <a:r>
              <a:rPr lang="en-US" dirty="0"/>
              <a:t>b)</a:t>
            </a:r>
          </a:p>
        </p:txBody>
      </p:sp>
      <p:grpSp>
        <p:nvGrpSpPr>
          <p:cNvPr id="73" name="Group 72">
            <a:extLst>
              <a:ext uri="{FF2B5EF4-FFF2-40B4-BE49-F238E27FC236}">
                <a16:creationId xmlns:a16="http://schemas.microsoft.com/office/drawing/2014/main" id="{B3393CF3-7729-429E-870E-C91642DF5E69}"/>
              </a:ext>
            </a:extLst>
          </p:cNvPr>
          <p:cNvGrpSpPr/>
          <p:nvPr/>
        </p:nvGrpSpPr>
        <p:grpSpPr>
          <a:xfrm>
            <a:off x="9373256" y="2685756"/>
            <a:ext cx="728651" cy="402484"/>
            <a:chOff x="1530991" y="4556496"/>
            <a:chExt cx="975701" cy="536310"/>
          </a:xfrm>
        </p:grpSpPr>
        <p:sp>
          <p:nvSpPr>
            <p:cNvPr id="71" name="Rectangle 70">
              <a:extLst>
                <a:ext uri="{FF2B5EF4-FFF2-40B4-BE49-F238E27FC236}">
                  <a16:creationId xmlns:a16="http://schemas.microsoft.com/office/drawing/2014/main" id="{01B1FDDE-A5FD-489B-A2C7-85E0366660A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a:extLst>
                <a:ext uri="{FF2B5EF4-FFF2-40B4-BE49-F238E27FC236}">
                  <a16:creationId xmlns:a16="http://schemas.microsoft.com/office/drawing/2014/main" id="{DD7718E4-55E4-4ABE-A634-F74D79335758}"/>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lowchart: Connector 67">
              <a:extLst>
                <a:ext uri="{FF2B5EF4-FFF2-40B4-BE49-F238E27FC236}">
                  <a16:creationId xmlns:a16="http://schemas.microsoft.com/office/drawing/2014/main" id="{526307C1-D12D-428D-A000-C08EDA5C0D47}"/>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5FADF267-54CD-424B-AB2E-C3DC20D52AFC}"/>
                </a:ext>
              </a:extLst>
            </p:cNvPr>
            <p:cNvSpPr txBox="1"/>
            <p:nvPr/>
          </p:nvSpPr>
          <p:spPr>
            <a:xfrm>
              <a:off x="1645701" y="4556496"/>
              <a:ext cx="732387" cy="307584"/>
            </a:xfrm>
            <a:prstGeom prst="rect">
              <a:avLst/>
            </a:prstGeom>
            <a:noFill/>
          </p:spPr>
          <p:txBody>
            <a:bodyPr wrap="none" rtlCol="0">
              <a:spAutoFit/>
            </a:bodyPr>
            <a:lstStyle/>
            <a:p>
              <a:r>
                <a:rPr lang="en-US" sz="900" dirty="0"/>
                <a:t>Peptide</a:t>
              </a:r>
            </a:p>
          </p:txBody>
        </p:sp>
        <p:sp>
          <p:nvSpPr>
            <p:cNvPr id="70" name="TextBox 69">
              <a:extLst>
                <a:ext uri="{FF2B5EF4-FFF2-40B4-BE49-F238E27FC236}">
                  <a16:creationId xmlns:a16="http://schemas.microsoft.com/office/drawing/2014/main" id="{69ECCB2D-1F8A-4B46-8C81-DFCF8F9E8F4C}"/>
                </a:ext>
              </a:extLst>
            </p:cNvPr>
            <p:cNvSpPr txBox="1"/>
            <p:nvPr/>
          </p:nvSpPr>
          <p:spPr>
            <a:xfrm>
              <a:off x="1654101" y="4785221"/>
              <a:ext cx="852591" cy="307585"/>
            </a:xfrm>
            <a:prstGeom prst="rect">
              <a:avLst/>
            </a:prstGeom>
            <a:noFill/>
          </p:spPr>
          <p:txBody>
            <a:bodyPr wrap="none" rtlCol="0">
              <a:spAutoFit/>
            </a:bodyPr>
            <a:lstStyle/>
            <a:p>
              <a:r>
                <a:rPr lang="en-US" sz="900" dirty="0"/>
                <a:t>Spectrum</a:t>
              </a:r>
            </a:p>
          </p:txBody>
        </p:sp>
      </p:grpSp>
    </p:spTree>
    <p:extLst>
      <p:ext uri="{BB962C8B-B14F-4D97-AF65-F5344CB8AC3E}">
        <p14:creationId xmlns:p14="http://schemas.microsoft.com/office/powerpoint/2010/main" val="42822557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Picture 32" descr="Chart, scatter chart&#10;&#10;Description automatically generated">
            <a:extLst>
              <a:ext uri="{FF2B5EF4-FFF2-40B4-BE49-F238E27FC236}">
                <a16:creationId xmlns:a16="http://schemas.microsoft.com/office/drawing/2014/main" id="{73169254-9233-4F4A-81B8-4140B90F65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01244" y="4632121"/>
            <a:ext cx="2358956" cy="1769217"/>
          </a:xfrm>
          <a:prstGeom prst="rect">
            <a:avLst/>
          </a:prstGeom>
        </p:spPr>
      </p:pic>
      <p:pic>
        <p:nvPicPr>
          <p:cNvPr id="21" name="Picture 20" descr="A screenshot of a computer&#10;&#10;Description automatically generated with low confidence">
            <a:extLst>
              <a:ext uri="{FF2B5EF4-FFF2-40B4-BE49-F238E27FC236}">
                <a16:creationId xmlns:a16="http://schemas.microsoft.com/office/drawing/2014/main" id="{4B0E2B2D-B673-4003-8E4F-829EC7361F4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60201" y="2272561"/>
            <a:ext cx="5731799" cy="4585439"/>
          </a:xfrm>
          <a:prstGeom prst="rect">
            <a:avLst/>
          </a:prstGeom>
        </p:spPr>
      </p:pic>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5"/>
            <a:ext cx="10515600" cy="494747"/>
          </a:xfrm>
        </p:spPr>
        <p:txBody>
          <a:bodyPr>
            <a:normAutofit/>
          </a:bodyPr>
          <a:lstStyle/>
          <a:p>
            <a:r>
              <a:rPr lang="en-US" sz="2800" dirty="0"/>
              <a:t>Proteome Tools Dataset (Precursor Mass 1500Da +- 1Da)</a:t>
            </a:r>
          </a:p>
        </p:txBody>
      </p:sp>
      <p:sp>
        <p:nvSpPr>
          <p:cNvPr id="18" name="Rectangle 17">
            <a:extLst>
              <a:ext uri="{FF2B5EF4-FFF2-40B4-BE49-F238E27FC236}">
                <a16:creationId xmlns:a16="http://schemas.microsoft.com/office/drawing/2014/main" id="{1A63C70C-F645-4DAE-9D52-9E557BFE4695}"/>
              </a:ext>
            </a:extLst>
          </p:cNvPr>
          <p:cNvSpPr/>
          <p:nvPr/>
        </p:nvSpPr>
        <p:spPr>
          <a:xfrm>
            <a:off x="9131417" y="5281566"/>
            <a:ext cx="247475" cy="26425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Connector 19">
            <a:extLst>
              <a:ext uri="{FF2B5EF4-FFF2-40B4-BE49-F238E27FC236}">
                <a16:creationId xmlns:a16="http://schemas.microsoft.com/office/drawing/2014/main" id="{01D50E07-3F5B-4380-B793-EDD337E0B1B4}"/>
              </a:ext>
            </a:extLst>
          </p:cNvPr>
          <p:cNvCxnSpPr>
            <a:cxnSpLocks/>
          </p:cNvCxnSpPr>
          <p:nvPr/>
        </p:nvCxnSpPr>
        <p:spPr>
          <a:xfrm flipH="1" flipV="1">
            <a:off x="5989739" y="4978773"/>
            <a:ext cx="3141679" cy="302795"/>
          </a:xfrm>
          <a:prstGeom prst="line">
            <a:avLst/>
          </a:prstGeom>
        </p:spPr>
        <p:style>
          <a:lnRef idx="1">
            <a:schemeClr val="dk1"/>
          </a:lnRef>
          <a:fillRef idx="0">
            <a:schemeClr val="dk1"/>
          </a:fillRef>
          <a:effectRef idx="0">
            <a:schemeClr val="dk1"/>
          </a:effectRef>
          <a:fontRef idx="minor">
            <a:schemeClr val="tx1"/>
          </a:fontRef>
        </p:style>
      </p:cxnSp>
      <p:pic>
        <p:nvPicPr>
          <p:cNvPr id="38" name="Picture 37" descr="Chart, scatter chart&#10;&#10;Description automatically generated">
            <a:extLst>
              <a:ext uri="{FF2B5EF4-FFF2-40B4-BE49-F238E27FC236}">
                <a16:creationId xmlns:a16="http://schemas.microsoft.com/office/drawing/2014/main" id="{61ACFA89-AC1D-4F3D-9896-3E59C8D26D5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101244" y="2694279"/>
            <a:ext cx="2358956" cy="1769217"/>
          </a:xfrm>
          <a:prstGeom prst="rect">
            <a:avLst/>
          </a:prstGeom>
        </p:spPr>
      </p:pic>
      <p:cxnSp>
        <p:nvCxnSpPr>
          <p:cNvPr id="22" name="Straight Connector 21">
            <a:extLst>
              <a:ext uri="{FF2B5EF4-FFF2-40B4-BE49-F238E27FC236}">
                <a16:creationId xmlns:a16="http://schemas.microsoft.com/office/drawing/2014/main" id="{B4827745-2CFD-4CB4-9203-AD54138E6697}"/>
              </a:ext>
            </a:extLst>
          </p:cNvPr>
          <p:cNvCxnSpPr>
            <a:cxnSpLocks/>
          </p:cNvCxnSpPr>
          <p:nvPr/>
        </p:nvCxnSpPr>
        <p:spPr>
          <a:xfrm flipH="1">
            <a:off x="5989739" y="5545820"/>
            <a:ext cx="3141679" cy="385190"/>
          </a:xfrm>
          <a:prstGeom prst="line">
            <a:avLst/>
          </a:prstGeom>
        </p:spPr>
        <p:style>
          <a:lnRef idx="1">
            <a:schemeClr val="dk1"/>
          </a:lnRef>
          <a:fillRef idx="0">
            <a:schemeClr val="dk1"/>
          </a:fillRef>
          <a:effectRef idx="0">
            <a:schemeClr val="dk1"/>
          </a:effectRef>
          <a:fontRef idx="minor">
            <a:schemeClr val="tx1"/>
          </a:fontRef>
        </p:style>
      </p:cxnSp>
      <p:sp>
        <p:nvSpPr>
          <p:cNvPr id="27" name="Rectangle 26">
            <a:extLst>
              <a:ext uri="{FF2B5EF4-FFF2-40B4-BE49-F238E27FC236}">
                <a16:creationId xmlns:a16="http://schemas.microsoft.com/office/drawing/2014/main" id="{9AAFCA83-2232-43EF-B256-EEE032F23D34}"/>
              </a:ext>
            </a:extLst>
          </p:cNvPr>
          <p:cNvSpPr/>
          <p:nvPr/>
        </p:nvSpPr>
        <p:spPr>
          <a:xfrm>
            <a:off x="8734338" y="4085439"/>
            <a:ext cx="247475" cy="23059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9" name="Straight Connector 28">
            <a:extLst>
              <a:ext uri="{FF2B5EF4-FFF2-40B4-BE49-F238E27FC236}">
                <a16:creationId xmlns:a16="http://schemas.microsoft.com/office/drawing/2014/main" id="{4AFC2137-2E8B-4A11-82B8-D0E04820B80F}"/>
              </a:ext>
            </a:extLst>
          </p:cNvPr>
          <p:cNvCxnSpPr>
            <a:cxnSpLocks/>
          </p:cNvCxnSpPr>
          <p:nvPr/>
        </p:nvCxnSpPr>
        <p:spPr>
          <a:xfrm flipH="1" flipV="1">
            <a:off x="5989740" y="3053489"/>
            <a:ext cx="2744598" cy="1031950"/>
          </a:xfrm>
          <a:prstGeom prst="line">
            <a:avLst/>
          </a:prstGeom>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C04DA262-DD1B-4CAA-8E23-1413DDA2E836}"/>
              </a:ext>
            </a:extLst>
          </p:cNvPr>
          <p:cNvCxnSpPr>
            <a:cxnSpLocks/>
          </p:cNvCxnSpPr>
          <p:nvPr/>
        </p:nvCxnSpPr>
        <p:spPr>
          <a:xfrm flipH="1" flipV="1">
            <a:off x="5989740" y="3992208"/>
            <a:ext cx="2744597" cy="323829"/>
          </a:xfrm>
          <a:prstGeom prst="line">
            <a:avLst/>
          </a:prstGeom>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A5F8A1F2-A71D-4DAE-9145-AF4A0E42EC88}"/>
              </a:ext>
            </a:extLst>
          </p:cNvPr>
          <p:cNvSpPr txBox="1"/>
          <p:nvPr/>
        </p:nvSpPr>
        <p:spPr>
          <a:xfrm>
            <a:off x="838201" y="1758960"/>
            <a:ext cx="3022952" cy="1107996"/>
          </a:xfrm>
          <a:prstGeom prst="rect">
            <a:avLst/>
          </a:prstGeom>
          <a:noFill/>
        </p:spPr>
        <p:txBody>
          <a:bodyPr wrap="square" rtlCol="0">
            <a:spAutoFit/>
          </a:bodyPr>
          <a:lstStyle/>
          <a:p>
            <a:r>
              <a:rPr lang="en-US" sz="1100" dirty="0"/>
              <a:t>Each cluster in the figure represents a peptide and its corresponding spectra. As can be seen, for most peptides, spectra with different charges are projected close to the peptide. However, there are cases (</a:t>
            </a:r>
            <a:r>
              <a:rPr lang="en-US" sz="1100" dirty="0" err="1"/>
              <a:t>subfig</a:t>
            </a:r>
            <a:r>
              <a:rPr lang="en-US" sz="1100" dirty="0"/>
              <a:t> a and b) where the spectra with charge 3 are farther than those with charge 2.</a:t>
            </a:r>
          </a:p>
        </p:txBody>
      </p:sp>
      <p:sp>
        <p:nvSpPr>
          <p:cNvPr id="36" name="TextBox 35">
            <a:extLst>
              <a:ext uri="{FF2B5EF4-FFF2-40B4-BE49-F238E27FC236}">
                <a16:creationId xmlns:a16="http://schemas.microsoft.com/office/drawing/2014/main" id="{8211CE96-13CC-42DC-B3EB-F47F1B5F5003}"/>
              </a:ext>
            </a:extLst>
          </p:cNvPr>
          <p:cNvSpPr txBox="1"/>
          <p:nvPr/>
        </p:nvSpPr>
        <p:spPr>
          <a:xfrm>
            <a:off x="3872372" y="3059668"/>
            <a:ext cx="365806" cy="369332"/>
          </a:xfrm>
          <a:prstGeom prst="rect">
            <a:avLst/>
          </a:prstGeom>
          <a:noFill/>
        </p:spPr>
        <p:txBody>
          <a:bodyPr wrap="none" rtlCol="0">
            <a:spAutoFit/>
          </a:bodyPr>
          <a:lstStyle/>
          <a:p>
            <a:r>
              <a:rPr lang="en-US" dirty="0"/>
              <a:t>a)</a:t>
            </a:r>
          </a:p>
        </p:txBody>
      </p:sp>
      <p:sp>
        <p:nvSpPr>
          <p:cNvPr id="37" name="TextBox 36">
            <a:extLst>
              <a:ext uri="{FF2B5EF4-FFF2-40B4-BE49-F238E27FC236}">
                <a16:creationId xmlns:a16="http://schemas.microsoft.com/office/drawing/2014/main" id="{83ACE920-DF24-48FC-8E68-B83E94C279EC}"/>
              </a:ext>
            </a:extLst>
          </p:cNvPr>
          <p:cNvSpPr txBox="1"/>
          <p:nvPr/>
        </p:nvSpPr>
        <p:spPr>
          <a:xfrm>
            <a:off x="3861152" y="4978773"/>
            <a:ext cx="377026" cy="369332"/>
          </a:xfrm>
          <a:prstGeom prst="rect">
            <a:avLst/>
          </a:prstGeom>
          <a:noFill/>
        </p:spPr>
        <p:txBody>
          <a:bodyPr wrap="none" rtlCol="0">
            <a:spAutoFit/>
          </a:bodyPr>
          <a:lstStyle/>
          <a:p>
            <a:r>
              <a:rPr lang="en-US" dirty="0"/>
              <a:t>b)</a:t>
            </a:r>
          </a:p>
        </p:txBody>
      </p:sp>
      <p:grpSp>
        <p:nvGrpSpPr>
          <p:cNvPr id="23" name="Group 22">
            <a:extLst>
              <a:ext uri="{FF2B5EF4-FFF2-40B4-BE49-F238E27FC236}">
                <a16:creationId xmlns:a16="http://schemas.microsoft.com/office/drawing/2014/main" id="{08259667-D6EB-4E8A-9FB8-120A71DAE022}"/>
              </a:ext>
            </a:extLst>
          </p:cNvPr>
          <p:cNvGrpSpPr/>
          <p:nvPr/>
        </p:nvGrpSpPr>
        <p:grpSpPr>
          <a:xfrm>
            <a:off x="10853913" y="2740284"/>
            <a:ext cx="728651" cy="402484"/>
            <a:chOff x="1530991" y="4556496"/>
            <a:chExt cx="975701" cy="536310"/>
          </a:xfrm>
        </p:grpSpPr>
        <p:sp>
          <p:nvSpPr>
            <p:cNvPr id="24" name="Rectangle 23">
              <a:extLst>
                <a:ext uri="{FF2B5EF4-FFF2-40B4-BE49-F238E27FC236}">
                  <a16:creationId xmlns:a16="http://schemas.microsoft.com/office/drawing/2014/main" id="{0E3E32F2-E0EC-4B55-BC72-DBE187B9BA8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Connector 24">
              <a:extLst>
                <a:ext uri="{FF2B5EF4-FFF2-40B4-BE49-F238E27FC236}">
                  <a16:creationId xmlns:a16="http://schemas.microsoft.com/office/drawing/2014/main" id="{32D81BC3-54AE-484E-A852-0C033181114B}"/>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Flowchart: Connector 27">
              <a:extLst>
                <a:ext uri="{FF2B5EF4-FFF2-40B4-BE49-F238E27FC236}">
                  <a16:creationId xmlns:a16="http://schemas.microsoft.com/office/drawing/2014/main" id="{1BA279CB-1688-4E18-99B3-AC8D78A925F5}"/>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a:extLst>
                <a:ext uri="{FF2B5EF4-FFF2-40B4-BE49-F238E27FC236}">
                  <a16:creationId xmlns:a16="http://schemas.microsoft.com/office/drawing/2014/main" id="{9371F5B6-D4E8-4C12-B5C4-3E9B8AF49339}"/>
                </a:ext>
              </a:extLst>
            </p:cNvPr>
            <p:cNvSpPr txBox="1"/>
            <p:nvPr/>
          </p:nvSpPr>
          <p:spPr>
            <a:xfrm>
              <a:off x="1645701" y="4556496"/>
              <a:ext cx="732387" cy="307584"/>
            </a:xfrm>
            <a:prstGeom prst="rect">
              <a:avLst/>
            </a:prstGeom>
            <a:noFill/>
          </p:spPr>
          <p:txBody>
            <a:bodyPr wrap="none" rtlCol="0">
              <a:spAutoFit/>
            </a:bodyPr>
            <a:lstStyle/>
            <a:p>
              <a:r>
                <a:rPr lang="en-US" sz="900" dirty="0"/>
                <a:t>Peptide</a:t>
              </a:r>
            </a:p>
          </p:txBody>
        </p:sp>
        <p:sp>
          <p:nvSpPr>
            <p:cNvPr id="32" name="TextBox 31">
              <a:extLst>
                <a:ext uri="{FF2B5EF4-FFF2-40B4-BE49-F238E27FC236}">
                  <a16:creationId xmlns:a16="http://schemas.microsoft.com/office/drawing/2014/main" id="{BE86736D-C47A-4212-BD9B-7D2DD2367AC9}"/>
                </a:ext>
              </a:extLst>
            </p:cNvPr>
            <p:cNvSpPr txBox="1"/>
            <p:nvPr/>
          </p:nvSpPr>
          <p:spPr>
            <a:xfrm>
              <a:off x="1654101" y="4785221"/>
              <a:ext cx="852591" cy="307585"/>
            </a:xfrm>
            <a:prstGeom prst="rect">
              <a:avLst/>
            </a:prstGeom>
            <a:noFill/>
          </p:spPr>
          <p:txBody>
            <a:bodyPr wrap="none" rtlCol="0">
              <a:spAutoFit/>
            </a:bodyPr>
            <a:lstStyle/>
            <a:p>
              <a:r>
                <a:rPr lang="en-US" sz="900" dirty="0"/>
                <a:t>Spectrum</a:t>
              </a:r>
            </a:p>
          </p:txBody>
        </p:sp>
      </p:grpSp>
      <p:sp>
        <p:nvSpPr>
          <p:cNvPr id="26" name="Rectangle 25">
            <a:extLst>
              <a:ext uri="{FF2B5EF4-FFF2-40B4-BE49-F238E27FC236}">
                <a16:creationId xmlns:a16="http://schemas.microsoft.com/office/drawing/2014/main" id="{DE580ABD-1967-432B-AAEF-C7DE7B177668}"/>
              </a:ext>
            </a:extLst>
          </p:cNvPr>
          <p:cNvSpPr/>
          <p:nvPr/>
        </p:nvSpPr>
        <p:spPr>
          <a:xfrm>
            <a:off x="9378892" y="4632121"/>
            <a:ext cx="897467" cy="76129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D4ED70E4-DEC7-44F5-B586-ED5CE3836CD4}"/>
              </a:ext>
            </a:extLst>
          </p:cNvPr>
          <p:cNvSpPr txBox="1"/>
          <p:nvPr/>
        </p:nvSpPr>
        <p:spPr>
          <a:xfrm>
            <a:off x="10032684" y="4316037"/>
            <a:ext cx="1108445" cy="369332"/>
          </a:xfrm>
          <a:prstGeom prst="rect">
            <a:avLst/>
          </a:prstGeom>
          <a:noFill/>
        </p:spPr>
        <p:txBody>
          <a:bodyPr wrap="none" rtlCol="0">
            <a:spAutoFit/>
          </a:bodyPr>
          <a:lstStyle/>
          <a:p>
            <a:r>
              <a:rPr lang="en-US" dirty="0"/>
              <a:t>Next slide</a:t>
            </a:r>
          </a:p>
        </p:txBody>
      </p:sp>
    </p:spTree>
    <p:extLst>
      <p:ext uri="{BB962C8B-B14F-4D97-AF65-F5344CB8AC3E}">
        <p14:creationId xmlns:p14="http://schemas.microsoft.com/office/powerpoint/2010/main" val="33648572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6"/>
            <a:ext cx="10515600" cy="450254"/>
          </a:xfrm>
        </p:spPr>
        <p:txBody>
          <a:bodyPr>
            <a:normAutofit fontScale="90000"/>
          </a:bodyPr>
          <a:lstStyle/>
          <a:p>
            <a:r>
              <a:rPr lang="en-US" sz="2800" dirty="0"/>
              <a:t>Proteome Tools Dataset (Precursor Mass 1500Da +- 1Da)</a:t>
            </a:r>
          </a:p>
        </p:txBody>
      </p:sp>
      <p:sp>
        <p:nvSpPr>
          <p:cNvPr id="35" name="TextBox 34">
            <a:extLst>
              <a:ext uri="{FF2B5EF4-FFF2-40B4-BE49-F238E27FC236}">
                <a16:creationId xmlns:a16="http://schemas.microsoft.com/office/drawing/2014/main" id="{A5F8A1F2-A71D-4DAE-9145-AF4A0E42EC88}"/>
              </a:ext>
            </a:extLst>
          </p:cNvPr>
          <p:cNvSpPr txBox="1"/>
          <p:nvPr/>
        </p:nvSpPr>
        <p:spPr>
          <a:xfrm>
            <a:off x="838200" y="1715914"/>
            <a:ext cx="3220985" cy="1169551"/>
          </a:xfrm>
          <a:prstGeom prst="rect">
            <a:avLst/>
          </a:prstGeom>
          <a:noFill/>
        </p:spPr>
        <p:txBody>
          <a:bodyPr wrap="square" rtlCol="0">
            <a:spAutoFit/>
          </a:bodyPr>
          <a:lstStyle/>
          <a:p>
            <a:r>
              <a:rPr lang="en-US" sz="1400" b="1" dirty="0"/>
              <a:t>Zoom in from the previous slide</a:t>
            </a:r>
            <a:r>
              <a:rPr lang="en-US" sz="1400" dirty="0"/>
              <a:t>.</a:t>
            </a:r>
          </a:p>
          <a:p>
            <a:r>
              <a:rPr lang="en-US" sz="1400" dirty="0"/>
              <a:t>This 2D mapping shows an example where spectra with charge 3 or 4 can map far enough from the peptide that they can overlap with other clusters.</a:t>
            </a:r>
          </a:p>
        </p:txBody>
      </p:sp>
      <p:pic>
        <p:nvPicPr>
          <p:cNvPr id="5" name="Picture 4" descr="Chart, scatter chart&#10;&#10;Description automatically generated">
            <a:extLst>
              <a:ext uri="{FF2B5EF4-FFF2-40B4-BE49-F238E27FC236}">
                <a16:creationId xmlns:a16="http://schemas.microsoft.com/office/drawing/2014/main" id="{C603D1AA-CD1C-4AE1-A9CF-145AB82EA5D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05200" y="815379"/>
            <a:ext cx="7553277" cy="6042622"/>
          </a:xfrm>
          <a:prstGeom prst="rect">
            <a:avLst/>
          </a:prstGeom>
        </p:spPr>
      </p:pic>
      <p:grpSp>
        <p:nvGrpSpPr>
          <p:cNvPr id="73" name="Group 72">
            <a:extLst>
              <a:ext uri="{FF2B5EF4-FFF2-40B4-BE49-F238E27FC236}">
                <a16:creationId xmlns:a16="http://schemas.microsoft.com/office/drawing/2014/main" id="{B3393CF3-7729-429E-870E-C91642DF5E69}"/>
              </a:ext>
            </a:extLst>
          </p:cNvPr>
          <p:cNvGrpSpPr/>
          <p:nvPr/>
        </p:nvGrpSpPr>
        <p:grpSpPr>
          <a:xfrm>
            <a:off x="9118600" y="1481950"/>
            <a:ext cx="1152078" cy="606248"/>
            <a:chOff x="1530991" y="4560517"/>
            <a:chExt cx="960539" cy="517219"/>
          </a:xfrm>
        </p:grpSpPr>
        <p:sp>
          <p:nvSpPr>
            <p:cNvPr id="71" name="Rectangle 70">
              <a:extLst>
                <a:ext uri="{FF2B5EF4-FFF2-40B4-BE49-F238E27FC236}">
                  <a16:creationId xmlns:a16="http://schemas.microsoft.com/office/drawing/2014/main" id="{01B1FDDE-A5FD-489B-A2C7-85E0366660A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a:extLst>
                <a:ext uri="{FF2B5EF4-FFF2-40B4-BE49-F238E27FC236}">
                  <a16:creationId xmlns:a16="http://schemas.microsoft.com/office/drawing/2014/main" id="{DD7718E4-55E4-4ABE-A634-F74D79335758}"/>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lowchart: Connector 67">
              <a:extLst>
                <a:ext uri="{FF2B5EF4-FFF2-40B4-BE49-F238E27FC236}">
                  <a16:creationId xmlns:a16="http://schemas.microsoft.com/office/drawing/2014/main" id="{526307C1-D12D-428D-A000-C08EDA5C0D47}"/>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5FADF267-54CD-424B-AB2E-C3DC20D52AFC}"/>
                </a:ext>
              </a:extLst>
            </p:cNvPr>
            <p:cNvSpPr txBox="1"/>
            <p:nvPr/>
          </p:nvSpPr>
          <p:spPr>
            <a:xfrm>
              <a:off x="1671034" y="4564201"/>
              <a:ext cx="485260" cy="197513"/>
            </a:xfrm>
            <a:prstGeom prst="rect">
              <a:avLst/>
            </a:prstGeom>
            <a:noFill/>
          </p:spPr>
          <p:txBody>
            <a:bodyPr wrap="none" rtlCol="0">
              <a:spAutoFit/>
            </a:bodyPr>
            <a:lstStyle/>
            <a:p>
              <a:r>
                <a:rPr lang="en-US" sz="1400" dirty="0"/>
                <a:t>Peptide</a:t>
              </a:r>
            </a:p>
          </p:txBody>
        </p:sp>
        <p:sp>
          <p:nvSpPr>
            <p:cNvPr id="70" name="TextBox 69">
              <a:extLst>
                <a:ext uri="{FF2B5EF4-FFF2-40B4-BE49-F238E27FC236}">
                  <a16:creationId xmlns:a16="http://schemas.microsoft.com/office/drawing/2014/main" id="{69ECCB2D-1F8A-4B46-8C81-DFCF8F9E8F4C}"/>
                </a:ext>
              </a:extLst>
            </p:cNvPr>
            <p:cNvSpPr txBox="1"/>
            <p:nvPr/>
          </p:nvSpPr>
          <p:spPr>
            <a:xfrm>
              <a:off x="1671034" y="4789878"/>
              <a:ext cx="723402" cy="197513"/>
            </a:xfrm>
            <a:prstGeom prst="rect">
              <a:avLst/>
            </a:prstGeom>
            <a:noFill/>
          </p:spPr>
          <p:txBody>
            <a:bodyPr wrap="none" rtlCol="0">
              <a:spAutoFit/>
            </a:bodyPr>
            <a:lstStyle/>
            <a:p>
              <a:r>
                <a:rPr lang="en-US" sz="1400" dirty="0"/>
                <a:t>Spectrum</a:t>
              </a:r>
            </a:p>
          </p:txBody>
        </p:sp>
      </p:grpSp>
    </p:spTree>
    <p:extLst>
      <p:ext uri="{BB962C8B-B14F-4D97-AF65-F5344CB8AC3E}">
        <p14:creationId xmlns:p14="http://schemas.microsoft.com/office/powerpoint/2010/main" val="40457084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Chart, scatter chart&#10;&#10;Description automatically generated">
            <a:extLst>
              <a:ext uri="{FF2B5EF4-FFF2-40B4-BE49-F238E27FC236}">
                <a16:creationId xmlns:a16="http://schemas.microsoft.com/office/drawing/2014/main" id="{A748EC5B-5CF0-4A14-9D30-8DE5B97E279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53339" y="587071"/>
            <a:ext cx="7838661" cy="6270929"/>
          </a:xfrm>
          <a:prstGeom prst="rect">
            <a:avLst/>
          </a:prstGeom>
        </p:spPr>
      </p:pic>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6"/>
            <a:ext cx="10515600" cy="450254"/>
          </a:xfrm>
        </p:spPr>
        <p:txBody>
          <a:bodyPr>
            <a:normAutofit fontScale="90000"/>
          </a:bodyPr>
          <a:lstStyle/>
          <a:p>
            <a:r>
              <a:rPr lang="en-US" sz="2800" dirty="0"/>
              <a:t>Proteome Tools Dataset (Precursor Mass 1700Da +- 1Da)</a:t>
            </a:r>
          </a:p>
        </p:txBody>
      </p:sp>
      <p:grpSp>
        <p:nvGrpSpPr>
          <p:cNvPr id="73" name="Group 72">
            <a:extLst>
              <a:ext uri="{FF2B5EF4-FFF2-40B4-BE49-F238E27FC236}">
                <a16:creationId xmlns:a16="http://schemas.microsoft.com/office/drawing/2014/main" id="{B3393CF3-7729-429E-870E-C91642DF5E69}"/>
              </a:ext>
            </a:extLst>
          </p:cNvPr>
          <p:cNvGrpSpPr/>
          <p:nvPr/>
        </p:nvGrpSpPr>
        <p:grpSpPr>
          <a:xfrm>
            <a:off x="10301357" y="1243775"/>
            <a:ext cx="1152078" cy="606248"/>
            <a:chOff x="1530991" y="4560517"/>
            <a:chExt cx="960539" cy="517219"/>
          </a:xfrm>
        </p:grpSpPr>
        <p:sp>
          <p:nvSpPr>
            <p:cNvPr id="71" name="Rectangle 70">
              <a:extLst>
                <a:ext uri="{FF2B5EF4-FFF2-40B4-BE49-F238E27FC236}">
                  <a16:creationId xmlns:a16="http://schemas.microsoft.com/office/drawing/2014/main" id="{01B1FDDE-A5FD-489B-A2C7-85E0366660A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a:extLst>
                <a:ext uri="{FF2B5EF4-FFF2-40B4-BE49-F238E27FC236}">
                  <a16:creationId xmlns:a16="http://schemas.microsoft.com/office/drawing/2014/main" id="{DD7718E4-55E4-4ABE-A634-F74D79335758}"/>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lowchart: Connector 67">
              <a:extLst>
                <a:ext uri="{FF2B5EF4-FFF2-40B4-BE49-F238E27FC236}">
                  <a16:creationId xmlns:a16="http://schemas.microsoft.com/office/drawing/2014/main" id="{526307C1-D12D-428D-A000-C08EDA5C0D47}"/>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5FADF267-54CD-424B-AB2E-C3DC20D52AFC}"/>
                </a:ext>
              </a:extLst>
            </p:cNvPr>
            <p:cNvSpPr txBox="1"/>
            <p:nvPr/>
          </p:nvSpPr>
          <p:spPr>
            <a:xfrm>
              <a:off x="1671034" y="4564201"/>
              <a:ext cx="485260" cy="197513"/>
            </a:xfrm>
            <a:prstGeom prst="rect">
              <a:avLst/>
            </a:prstGeom>
            <a:noFill/>
          </p:spPr>
          <p:txBody>
            <a:bodyPr wrap="none" rtlCol="0">
              <a:spAutoFit/>
            </a:bodyPr>
            <a:lstStyle/>
            <a:p>
              <a:r>
                <a:rPr lang="en-US" sz="1400" dirty="0"/>
                <a:t>Peptide</a:t>
              </a:r>
            </a:p>
          </p:txBody>
        </p:sp>
        <p:sp>
          <p:nvSpPr>
            <p:cNvPr id="70" name="TextBox 69">
              <a:extLst>
                <a:ext uri="{FF2B5EF4-FFF2-40B4-BE49-F238E27FC236}">
                  <a16:creationId xmlns:a16="http://schemas.microsoft.com/office/drawing/2014/main" id="{69ECCB2D-1F8A-4B46-8C81-DFCF8F9E8F4C}"/>
                </a:ext>
              </a:extLst>
            </p:cNvPr>
            <p:cNvSpPr txBox="1"/>
            <p:nvPr/>
          </p:nvSpPr>
          <p:spPr>
            <a:xfrm>
              <a:off x="1671034" y="4789878"/>
              <a:ext cx="723402" cy="197513"/>
            </a:xfrm>
            <a:prstGeom prst="rect">
              <a:avLst/>
            </a:prstGeom>
            <a:noFill/>
          </p:spPr>
          <p:txBody>
            <a:bodyPr wrap="none" rtlCol="0">
              <a:spAutoFit/>
            </a:bodyPr>
            <a:lstStyle/>
            <a:p>
              <a:r>
                <a:rPr lang="en-US" sz="1400" dirty="0"/>
                <a:t>Spectrum</a:t>
              </a:r>
            </a:p>
          </p:txBody>
        </p:sp>
      </p:grpSp>
    </p:spTree>
    <p:extLst>
      <p:ext uri="{BB962C8B-B14F-4D97-AF65-F5344CB8AC3E}">
        <p14:creationId xmlns:p14="http://schemas.microsoft.com/office/powerpoint/2010/main" val="10866552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scatter chart&#10;&#10;Description automatically generated">
            <a:extLst>
              <a:ext uri="{FF2B5EF4-FFF2-40B4-BE49-F238E27FC236}">
                <a16:creationId xmlns:a16="http://schemas.microsoft.com/office/drawing/2014/main" id="{1F4EB4C0-1AE4-423F-93B0-2F99353CDFC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52511" y="586409"/>
            <a:ext cx="7839489" cy="6271591"/>
          </a:xfrm>
          <a:prstGeom prst="rect">
            <a:avLst/>
          </a:prstGeom>
        </p:spPr>
      </p:pic>
      <p:grpSp>
        <p:nvGrpSpPr>
          <p:cNvPr id="73" name="Group 72">
            <a:extLst>
              <a:ext uri="{FF2B5EF4-FFF2-40B4-BE49-F238E27FC236}">
                <a16:creationId xmlns:a16="http://schemas.microsoft.com/office/drawing/2014/main" id="{B3393CF3-7729-429E-870E-C91642DF5E69}"/>
              </a:ext>
            </a:extLst>
          </p:cNvPr>
          <p:cNvGrpSpPr/>
          <p:nvPr/>
        </p:nvGrpSpPr>
        <p:grpSpPr>
          <a:xfrm>
            <a:off x="10301357" y="1243775"/>
            <a:ext cx="1152078" cy="606248"/>
            <a:chOff x="1530991" y="4560517"/>
            <a:chExt cx="960539" cy="517219"/>
          </a:xfrm>
        </p:grpSpPr>
        <p:sp>
          <p:nvSpPr>
            <p:cNvPr id="71" name="Rectangle 70">
              <a:extLst>
                <a:ext uri="{FF2B5EF4-FFF2-40B4-BE49-F238E27FC236}">
                  <a16:creationId xmlns:a16="http://schemas.microsoft.com/office/drawing/2014/main" id="{01B1FDDE-A5FD-489B-A2C7-85E0366660A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a:extLst>
                <a:ext uri="{FF2B5EF4-FFF2-40B4-BE49-F238E27FC236}">
                  <a16:creationId xmlns:a16="http://schemas.microsoft.com/office/drawing/2014/main" id="{DD7718E4-55E4-4ABE-A634-F74D79335758}"/>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lowchart: Connector 67">
              <a:extLst>
                <a:ext uri="{FF2B5EF4-FFF2-40B4-BE49-F238E27FC236}">
                  <a16:creationId xmlns:a16="http://schemas.microsoft.com/office/drawing/2014/main" id="{526307C1-D12D-428D-A000-C08EDA5C0D47}"/>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5FADF267-54CD-424B-AB2E-C3DC20D52AFC}"/>
                </a:ext>
              </a:extLst>
            </p:cNvPr>
            <p:cNvSpPr txBox="1"/>
            <p:nvPr/>
          </p:nvSpPr>
          <p:spPr>
            <a:xfrm>
              <a:off x="1671034" y="4564201"/>
              <a:ext cx="485260" cy="197513"/>
            </a:xfrm>
            <a:prstGeom prst="rect">
              <a:avLst/>
            </a:prstGeom>
            <a:noFill/>
          </p:spPr>
          <p:txBody>
            <a:bodyPr wrap="none" rtlCol="0">
              <a:spAutoFit/>
            </a:bodyPr>
            <a:lstStyle/>
            <a:p>
              <a:r>
                <a:rPr lang="en-US" sz="1400" dirty="0"/>
                <a:t>Peptide</a:t>
              </a:r>
            </a:p>
          </p:txBody>
        </p:sp>
        <p:sp>
          <p:nvSpPr>
            <p:cNvPr id="70" name="TextBox 69">
              <a:extLst>
                <a:ext uri="{FF2B5EF4-FFF2-40B4-BE49-F238E27FC236}">
                  <a16:creationId xmlns:a16="http://schemas.microsoft.com/office/drawing/2014/main" id="{69ECCB2D-1F8A-4B46-8C81-DFCF8F9E8F4C}"/>
                </a:ext>
              </a:extLst>
            </p:cNvPr>
            <p:cNvSpPr txBox="1"/>
            <p:nvPr/>
          </p:nvSpPr>
          <p:spPr>
            <a:xfrm>
              <a:off x="1671034" y="4789878"/>
              <a:ext cx="723402" cy="197513"/>
            </a:xfrm>
            <a:prstGeom prst="rect">
              <a:avLst/>
            </a:prstGeom>
            <a:noFill/>
          </p:spPr>
          <p:txBody>
            <a:bodyPr wrap="none" rtlCol="0">
              <a:spAutoFit/>
            </a:bodyPr>
            <a:lstStyle/>
            <a:p>
              <a:r>
                <a:rPr lang="en-US" sz="1400" dirty="0"/>
                <a:t>Spectrum</a:t>
              </a:r>
            </a:p>
          </p:txBody>
        </p:sp>
      </p:grpSp>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6"/>
            <a:ext cx="10515600" cy="450254"/>
          </a:xfrm>
        </p:spPr>
        <p:txBody>
          <a:bodyPr>
            <a:normAutofit fontScale="90000"/>
          </a:bodyPr>
          <a:lstStyle/>
          <a:p>
            <a:r>
              <a:rPr lang="en-US" sz="2800" dirty="0"/>
              <a:t>Proteome Tools Dataset (Precursor Mass 2300Da +- 1Da)</a:t>
            </a:r>
          </a:p>
        </p:txBody>
      </p:sp>
    </p:spTree>
    <p:extLst>
      <p:ext uri="{BB962C8B-B14F-4D97-AF65-F5344CB8AC3E}">
        <p14:creationId xmlns:p14="http://schemas.microsoft.com/office/powerpoint/2010/main" val="30340244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scatter chart&#10;&#10;Description automatically generated">
            <a:extLst>
              <a:ext uri="{FF2B5EF4-FFF2-40B4-BE49-F238E27FC236}">
                <a16:creationId xmlns:a16="http://schemas.microsoft.com/office/drawing/2014/main" id="{68310295-D42F-4590-9CB5-097DA6C22FB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64107" y="595686"/>
            <a:ext cx="7827893" cy="6262314"/>
          </a:xfrm>
          <a:prstGeom prst="rect">
            <a:avLst/>
          </a:prstGeom>
        </p:spPr>
      </p:pic>
      <p:grpSp>
        <p:nvGrpSpPr>
          <p:cNvPr id="73" name="Group 72">
            <a:extLst>
              <a:ext uri="{FF2B5EF4-FFF2-40B4-BE49-F238E27FC236}">
                <a16:creationId xmlns:a16="http://schemas.microsoft.com/office/drawing/2014/main" id="{B3393CF3-7729-429E-870E-C91642DF5E69}"/>
              </a:ext>
            </a:extLst>
          </p:cNvPr>
          <p:cNvGrpSpPr/>
          <p:nvPr/>
        </p:nvGrpSpPr>
        <p:grpSpPr>
          <a:xfrm>
            <a:off x="10301357" y="1243775"/>
            <a:ext cx="1152078" cy="606248"/>
            <a:chOff x="1530991" y="4560517"/>
            <a:chExt cx="960539" cy="517219"/>
          </a:xfrm>
        </p:grpSpPr>
        <p:sp>
          <p:nvSpPr>
            <p:cNvPr id="71" name="Rectangle 70">
              <a:extLst>
                <a:ext uri="{FF2B5EF4-FFF2-40B4-BE49-F238E27FC236}">
                  <a16:creationId xmlns:a16="http://schemas.microsoft.com/office/drawing/2014/main" id="{01B1FDDE-A5FD-489B-A2C7-85E0366660A3}"/>
                </a:ext>
              </a:extLst>
            </p:cNvPr>
            <p:cNvSpPr/>
            <p:nvPr/>
          </p:nvSpPr>
          <p:spPr>
            <a:xfrm>
              <a:off x="1530991" y="4560517"/>
              <a:ext cx="960539" cy="5172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a:extLst>
                <a:ext uri="{FF2B5EF4-FFF2-40B4-BE49-F238E27FC236}">
                  <a16:creationId xmlns:a16="http://schemas.microsoft.com/office/drawing/2014/main" id="{DD7718E4-55E4-4ABE-A634-F74D79335758}"/>
                </a:ext>
              </a:extLst>
            </p:cNvPr>
            <p:cNvSpPr/>
            <p:nvPr/>
          </p:nvSpPr>
          <p:spPr>
            <a:xfrm>
              <a:off x="1610046" y="4675682"/>
              <a:ext cx="71307" cy="69210"/>
            </a:xfrm>
            <a:prstGeom prst="flowChartConnector">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Flowchart: Connector 67">
              <a:extLst>
                <a:ext uri="{FF2B5EF4-FFF2-40B4-BE49-F238E27FC236}">
                  <a16:creationId xmlns:a16="http://schemas.microsoft.com/office/drawing/2014/main" id="{526307C1-D12D-428D-A000-C08EDA5C0D47}"/>
                </a:ext>
              </a:extLst>
            </p:cNvPr>
            <p:cNvSpPr/>
            <p:nvPr/>
          </p:nvSpPr>
          <p:spPr>
            <a:xfrm>
              <a:off x="1610046" y="4904632"/>
              <a:ext cx="71307" cy="6921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5FADF267-54CD-424B-AB2E-C3DC20D52AFC}"/>
                </a:ext>
              </a:extLst>
            </p:cNvPr>
            <p:cNvSpPr txBox="1"/>
            <p:nvPr/>
          </p:nvSpPr>
          <p:spPr>
            <a:xfrm>
              <a:off x="1671034" y="4564201"/>
              <a:ext cx="485260" cy="197513"/>
            </a:xfrm>
            <a:prstGeom prst="rect">
              <a:avLst/>
            </a:prstGeom>
            <a:noFill/>
          </p:spPr>
          <p:txBody>
            <a:bodyPr wrap="none" rtlCol="0">
              <a:spAutoFit/>
            </a:bodyPr>
            <a:lstStyle/>
            <a:p>
              <a:r>
                <a:rPr lang="en-US" sz="1400" dirty="0"/>
                <a:t>Peptide</a:t>
              </a:r>
            </a:p>
          </p:txBody>
        </p:sp>
        <p:sp>
          <p:nvSpPr>
            <p:cNvPr id="70" name="TextBox 69">
              <a:extLst>
                <a:ext uri="{FF2B5EF4-FFF2-40B4-BE49-F238E27FC236}">
                  <a16:creationId xmlns:a16="http://schemas.microsoft.com/office/drawing/2014/main" id="{69ECCB2D-1F8A-4B46-8C81-DFCF8F9E8F4C}"/>
                </a:ext>
              </a:extLst>
            </p:cNvPr>
            <p:cNvSpPr txBox="1"/>
            <p:nvPr/>
          </p:nvSpPr>
          <p:spPr>
            <a:xfrm>
              <a:off x="1671034" y="4789878"/>
              <a:ext cx="723402" cy="197513"/>
            </a:xfrm>
            <a:prstGeom prst="rect">
              <a:avLst/>
            </a:prstGeom>
            <a:noFill/>
          </p:spPr>
          <p:txBody>
            <a:bodyPr wrap="none" rtlCol="0">
              <a:spAutoFit/>
            </a:bodyPr>
            <a:lstStyle/>
            <a:p>
              <a:r>
                <a:rPr lang="en-US" sz="1400" dirty="0"/>
                <a:t>Spectrum</a:t>
              </a:r>
            </a:p>
          </p:txBody>
        </p:sp>
      </p:grpSp>
      <p:sp>
        <p:nvSpPr>
          <p:cNvPr id="2" name="Title 1">
            <a:extLst>
              <a:ext uri="{FF2B5EF4-FFF2-40B4-BE49-F238E27FC236}">
                <a16:creationId xmlns:a16="http://schemas.microsoft.com/office/drawing/2014/main" id="{EDD8D71D-F75E-4E1B-B133-00FD006678FA}"/>
              </a:ext>
            </a:extLst>
          </p:cNvPr>
          <p:cNvSpPr>
            <a:spLocks noGrp="1"/>
          </p:cNvSpPr>
          <p:nvPr>
            <p:ph type="title"/>
          </p:nvPr>
        </p:nvSpPr>
        <p:spPr>
          <a:xfrm>
            <a:off x="838200" y="365126"/>
            <a:ext cx="10515600" cy="450254"/>
          </a:xfrm>
        </p:spPr>
        <p:txBody>
          <a:bodyPr>
            <a:normAutofit fontScale="90000"/>
          </a:bodyPr>
          <a:lstStyle/>
          <a:p>
            <a:r>
              <a:rPr lang="en-US" sz="2800" dirty="0"/>
              <a:t>Proteome Tools Dataset (Precursor Mass 2500Da +- 1Da)</a:t>
            </a:r>
          </a:p>
        </p:txBody>
      </p:sp>
    </p:spTree>
    <p:extLst>
      <p:ext uri="{BB962C8B-B14F-4D97-AF65-F5344CB8AC3E}">
        <p14:creationId xmlns:p14="http://schemas.microsoft.com/office/powerpoint/2010/main" val="42666548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839</TotalTime>
  <Words>264</Words>
  <Application>Microsoft Office PowerPoint</Application>
  <PresentationFormat>Widescreen</PresentationFormat>
  <Paragraphs>35</Paragraphs>
  <Slides>7</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UMAP Projections</vt:lpstr>
      <vt:lpstr>Human HCD Phospho Dataset (Precursor Mass 2000Da +- 1Da)</vt:lpstr>
      <vt:lpstr>Proteome Tools Dataset (Precursor Mass 1500Da +- 1Da)</vt:lpstr>
      <vt:lpstr>Proteome Tools Dataset (Precursor Mass 1500Da +- 1Da)</vt:lpstr>
      <vt:lpstr>Proteome Tools Dataset (Precursor Mass 1700Da +- 1Da)</vt:lpstr>
      <vt:lpstr>Proteome Tools Dataset (Precursor Mass 2300Da +- 1Da)</vt:lpstr>
      <vt:lpstr>Proteome Tools Dataset (Precursor Mass 2500Da +- 1Da)</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MAP Projections</dc:title>
  <dc:creator>Muhammad Usman Tariq</dc:creator>
  <cp:lastModifiedBy>Muhammad Usman Tariq</cp:lastModifiedBy>
  <cp:revision>4</cp:revision>
  <dcterms:created xsi:type="dcterms:W3CDTF">2021-08-18T02:42:55Z</dcterms:created>
  <dcterms:modified xsi:type="dcterms:W3CDTF">2021-09-02T23:39:59Z</dcterms:modified>
</cp:coreProperties>
</file>